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6"/>
  </p:notesMasterIdLst>
  <p:sldIdLst>
    <p:sldId id="256" r:id="rId2"/>
    <p:sldId id="297" r:id="rId3"/>
    <p:sldId id="320" r:id="rId4"/>
    <p:sldId id="332" r:id="rId5"/>
    <p:sldId id="333" r:id="rId6"/>
    <p:sldId id="362" r:id="rId7"/>
    <p:sldId id="363" r:id="rId8"/>
    <p:sldId id="365" r:id="rId9"/>
    <p:sldId id="324" r:id="rId10"/>
    <p:sldId id="325" r:id="rId11"/>
    <p:sldId id="328" r:id="rId12"/>
    <p:sldId id="330" r:id="rId13"/>
    <p:sldId id="298" r:id="rId14"/>
    <p:sldId id="331" r:id="rId15"/>
    <p:sldId id="334" r:id="rId16"/>
    <p:sldId id="335" r:id="rId17"/>
    <p:sldId id="366" r:id="rId18"/>
    <p:sldId id="367" r:id="rId19"/>
    <p:sldId id="368" r:id="rId20"/>
    <p:sldId id="369" r:id="rId21"/>
    <p:sldId id="371" r:id="rId22"/>
    <p:sldId id="370" r:id="rId23"/>
    <p:sldId id="336" r:id="rId24"/>
    <p:sldId id="337" r:id="rId25"/>
    <p:sldId id="338" r:id="rId26"/>
    <p:sldId id="339" r:id="rId27"/>
    <p:sldId id="340" r:id="rId28"/>
    <p:sldId id="342" r:id="rId29"/>
    <p:sldId id="344" r:id="rId30"/>
    <p:sldId id="343" r:id="rId31"/>
    <p:sldId id="360" r:id="rId32"/>
    <p:sldId id="361" r:id="rId33"/>
    <p:sldId id="347" r:id="rId34"/>
    <p:sldId id="349" r:id="rId35"/>
    <p:sldId id="348" r:id="rId36"/>
    <p:sldId id="350" r:id="rId37"/>
    <p:sldId id="351" r:id="rId38"/>
    <p:sldId id="352" r:id="rId39"/>
    <p:sldId id="359" r:id="rId40"/>
    <p:sldId id="353" r:id="rId41"/>
    <p:sldId id="355" r:id="rId42"/>
    <p:sldId id="354" r:id="rId43"/>
    <p:sldId id="357" r:id="rId44"/>
    <p:sldId id="341" r:id="rId45"/>
    <p:sldId id="303" r:id="rId46"/>
    <p:sldId id="304" r:id="rId47"/>
    <p:sldId id="302" r:id="rId48"/>
    <p:sldId id="309" r:id="rId49"/>
    <p:sldId id="372" r:id="rId50"/>
    <p:sldId id="317" r:id="rId51"/>
    <p:sldId id="318" r:id="rId52"/>
    <p:sldId id="374" r:id="rId53"/>
    <p:sldId id="290" r:id="rId54"/>
    <p:sldId id="291" r:id="rId5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819" y="4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viewProps" Target="viewProps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presProps" Target="presProps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355B91-40E4-41BA-9F98-EE114E8F4034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391DDD-7076-4747-941D-B7D8D34702D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6.png"/></Relationships>
</file>

<file path=ppt/slides/_rels/slide18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8.png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2.png"/></Relationships>
</file>

<file path=ppt/slides/_rels/slide21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4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5.png"/><Relationship Id="rId4" Type="http://schemas.openxmlformats.org/officeDocument/2006/relationships/image" Target="../media/image84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2.png"/><Relationship Id="rId5" Type="http://schemas.openxmlformats.org/officeDocument/2006/relationships/image" Target="../media/image91.png"/><Relationship Id="rId4" Type="http://schemas.openxmlformats.org/officeDocument/2006/relationships/image" Target="../media/image90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png"/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0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98.png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png"/><Relationship Id="rId2" Type="http://schemas.openxmlformats.org/officeDocument/2006/relationships/image" Target="../media/image99.png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jpeg"/><Relationship Id="rId2" Type="http://schemas.openxmlformats.org/officeDocument/2006/relationships/image" Target="../media/image10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3.png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4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png"/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png"/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png"/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4.png"/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5.png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7.png"/><Relationship Id="rId2" Type="http://schemas.openxmlformats.org/officeDocument/2006/relationships/image" Target="../media/image1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9.png"/><Relationship Id="rId4" Type="http://schemas.openxmlformats.org/officeDocument/2006/relationships/image" Target="../media/image11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png"/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png"/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tif"/><Relationship Id="rId2" Type="http://schemas.openxmlformats.org/officeDocument/2006/relationships/image" Target="../media/image124.tif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png"/><Relationship Id="rId2" Type="http://schemas.openxmlformats.org/officeDocument/2006/relationships/image" Target="../media/image126.png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9.png"/><Relationship Id="rId2" Type="http://schemas.openxmlformats.org/officeDocument/2006/relationships/image" Target="../media/image12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-71470" y="1652141"/>
            <a:ext cx="5357819" cy="4448615"/>
            <a:chOff x="1071538" y="2152207"/>
            <a:chExt cx="5357819" cy="4448615"/>
          </a:xfrm>
        </p:grpSpPr>
        <p:grpSp>
          <p:nvGrpSpPr>
            <p:cNvPr id="47" name="组合 46"/>
            <p:cNvGrpSpPr/>
            <p:nvPr/>
          </p:nvGrpSpPr>
          <p:grpSpPr>
            <a:xfrm>
              <a:off x="1071538" y="2152207"/>
              <a:ext cx="3918208" cy="3848561"/>
              <a:chOff x="500034" y="2795149"/>
              <a:chExt cx="3918208" cy="3848561"/>
            </a:xfrm>
          </p:grpSpPr>
          <p:grpSp>
            <p:nvGrpSpPr>
              <p:cNvPr id="32" name="组合 31"/>
              <p:cNvGrpSpPr/>
              <p:nvPr/>
            </p:nvGrpSpPr>
            <p:grpSpPr>
              <a:xfrm>
                <a:off x="500034" y="3559734"/>
                <a:ext cx="1428760" cy="3083976"/>
                <a:chOff x="2285984" y="1000132"/>
                <a:chExt cx="1428760" cy="3083976"/>
              </a:xfrm>
            </p:grpSpPr>
            <p:sp>
              <p:nvSpPr>
                <p:cNvPr id="33" name="TextBox 32"/>
                <p:cNvSpPr txBox="1"/>
                <p:nvPr/>
              </p:nvSpPr>
              <p:spPr>
                <a:xfrm>
                  <a:off x="2285984" y="1000132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2285984" y="1155150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2285984" y="1428760"/>
                  <a:ext cx="14287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2357422" y="1714512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2428860" y="1940968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2428860" y="2357454"/>
                  <a:ext cx="8572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2428860" y="2726786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2428860" y="3012538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2428860" y="3714776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5KDa-</a:t>
                  </a:r>
                  <a:endParaRPr lang="zh-CN" altLang="en-US" dirty="0"/>
                </a:p>
              </p:txBody>
            </p:sp>
          </p:grpSp>
          <p:sp>
            <p:nvSpPr>
              <p:cNvPr id="43" name="TextBox 42"/>
              <p:cNvSpPr txBox="1"/>
              <p:nvPr/>
            </p:nvSpPr>
            <p:spPr>
              <a:xfrm rot="18900000">
                <a:off x="1808098" y="3125589"/>
                <a:ext cx="7858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Con.</a:t>
                </a:r>
                <a:r>
                  <a:rPr lang="en-US" altLang="zh-CN" dirty="0">
                    <a:solidFill>
                      <a:schemeClr val="bg1"/>
                    </a:solidFill>
                  </a:rPr>
                  <a:t>.</a:t>
                </a:r>
                <a:endParaRPr lang="zh-CN" altLang="en-US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8900000">
                <a:off x="2146214" y="2972866"/>
                <a:ext cx="121065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</a:lstStyle>
              <a:p>
                <a:r>
                  <a:rPr lang="en-US" altLang="zh-CN" dirty="0"/>
                  <a:t>Cd20</a:t>
                </a:r>
                <a:endParaRPr lang="zh-CN" altLang="en-US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8900000">
                <a:off x="2604370" y="3014983"/>
                <a:ext cx="9286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err="1"/>
                  <a:t>Azo</a:t>
                </a:r>
                <a:r>
                  <a:rPr lang="en-US" altLang="zh-CN" dirty="0">
                    <a:solidFill>
                      <a:schemeClr val="bg1"/>
                    </a:solidFill>
                  </a:rPr>
                  <a:t> </a:t>
                </a:r>
                <a:r>
                  <a:rPr lang="en-US" altLang="zh-CN" dirty="0"/>
                  <a:t>20</a:t>
                </a:r>
                <a:endParaRPr lang="zh-CN" altLang="en-US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8900000">
                <a:off x="2918044" y="2795149"/>
                <a:ext cx="150019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Azo20+Cd20</a:t>
                </a:r>
                <a:endParaRPr lang="zh-CN" altLang="en-US" dirty="0"/>
              </a:p>
            </p:txBody>
          </p:sp>
        </p:grp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000232" y="3000372"/>
              <a:ext cx="4429125" cy="3600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335822" y="3865014"/>
            <a:ext cx="4410075" cy="933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矩形 26"/>
          <p:cNvSpPr/>
          <p:nvPr/>
        </p:nvSpPr>
        <p:spPr>
          <a:xfrm>
            <a:off x="6000760" y="4357694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357158" y="642918"/>
            <a:ext cx="25003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 2C 2023.9.7-1 </a:t>
            </a: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430953" y="276912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692430" y="2500306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9B0BF4A5-F613-4319-A74A-A145EC251EC9}"/>
              </a:ext>
            </a:extLst>
          </p:cNvPr>
          <p:cNvCxnSpPr/>
          <p:nvPr/>
        </p:nvCxnSpPr>
        <p:spPr>
          <a:xfrm flipH="1">
            <a:off x="5429256" y="300037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5690733" y="2845354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29" name="矩形 28"/>
          <p:cNvSpPr/>
          <p:nvPr/>
        </p:nvSpPr>
        <p:spPr>
          <a:xfrm>
            <a:off x="5500694" y="342900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30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5292504" y="4208694"/>
            <a:ext cx="143500" cy="58437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00034" y="142852"/>
            <a:ext cx="2008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C  2023.10.1 2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143504" y="3071810"/>
            <a:ext cx="3600000" cy="9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 rot="-2700000">
            <a:off x="2755197" y="173404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3063878" y="152705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3459412" y="163490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3687208" y="1419053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14414" y="2214553"/>
            <a:ext cx="3600000" cy="7768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14414" y="3071810"/>
            <a:ext cx="3672000" cy="88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214414" y="4000504"/>
            <a:ext cx="3708000" cy="14496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428596" y="228599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57158" y="242886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28596" y="271462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28596" y="300037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28596" y="328612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28596" y="450057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428596" y="392906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428596" y="364331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28596" y="213097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857752" y="228599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026848" y="2071678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24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5572132" y="307181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5" name="矩形 24"/>
          <p:cNvSpPr/>
          <p:nvPr/>
        </p:nvSpPr>
        <p:spPr>
          <a:xfrm>
            <a:off x="5143504" y="2643182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6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4863876" y="3208562"/>
            <a:ext cx="143500" cy="58437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8" y="3429000"/>
            <a:ext cx="4212000" cy="111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矩形 3"/>
          <p:cNvSpPr/>
          <p:nvPr/>
        </p:nvSpPr>
        <p:spPr>
          <a:xfrm>
            <a:off x="714348" y="428604"/>
            <a:ext cx="2008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C  2023.10.3 2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 rot="-2700000">
            <a:off x="2766628" y="147390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3079663" y="133709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3452939" y="142338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3710842" y="122133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71538" y="2000240"/>
            <a:ext cx="4140000" cy="7924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071538" y="2786058"/>
            <a:ext cx="4140000" cy="582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071538" y="4572008"/>
            <a:ext cx="4176000" cy="1488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338941" y="221455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508037" y="200024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5572132" y="3845486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357818" y="400050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85720" y="221455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85720" y="248816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57158" y="277391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357158" y="305966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357158" y="3631172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357158" y="513137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351677" y="448842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357158" y="405980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85720" y="213097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57422" y="3071810"/>
            <a:ext cx="3780000" cy="998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矩形 3"/>
          <p:cNvSpPr/>
          <p:nvPr/>
        </p:nvSpPr>
        <p:spPr>
          <a:xfrm>
            <a:off x="1285852" y="714356"/>
            <a:ext cx="2008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C  2023.10.8 1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 rot="-2700000">
            <a:off x="4137802" y="137247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4466803" y="124952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4885943" y="132093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5163770" y="111887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364198" y="1857364"/>
            <a:ext cx="3708000" cy="604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357422" y="2504411"/>
            <a:ext cx="3708000" cy="5108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357422" y="4071942"/>
            <a:ext cx="3780000" cy="13542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184304" y="207167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6353400" y="1857364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6417495" y="3488296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203181" y="364331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500166" y="198809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500166" y="220241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1571604" y="255960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571604" y="29167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1571604" y="320254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1571604" y="441699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1566123" y="377404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4" name="矩形 23"/>
          <p:cNvSpPr/>
          <p:nvPr/>
        </p:nvSpPr>
        <p:spPr>
          <a:xfrm>
            <a:off x="1571604" y="355973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1500166" y="185736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714348" y="642918"/>
            <a:ext cx="6357982" cy="5572164"/>
            <a:chOff x="714348" y="642918"/>
            <a:chExt cx="6357982" cy="5572164"/>
          </a:xfrm>
        </p:grpSpPr>
        <p:grpSp>
          <p:nvGrpSpPr>
            <p:cNvPr id="3" name="组合 1"/>
            <p:cNvGrpSpPr/>
            <p:nvPr/>
          </p:nvGrpSpPr>
          <p:grpSpPr>
            <a:xfrm>
              <a:off x="1714480" y="2714620"/>
              <a:ext cx="5357850" cy="3500462"/>
              <a:chOff x="785786" y="3571876"/>
              <a:chExt cx="5357850" cy="3500462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714480" y="3571876"/>
                <a:ext cx="4420800" cy="12111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1714480" y="4714884"/>
                <a:ext cx="4420800" cy="11597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1" name="Picture 5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1722836" y="5857892"/>
                <a:ext cx="4420800" cy="11149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2" name="组合 22"/>
              <p:cNvGrpSpPr/>
              <p:nvPr/>
            </p:nvGrpSpPr>
            <p:grpSpPr>
              <a:xfrm>
                <a:off x="785786" y="3631172"/>
                <a:ext cx="1428760" cy="3441166"/>
                <a:chOff x="2428860" y="1071570"/>
                <a:chExt cx="1428760" cy="3441166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2428860" y="1071570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428860" y="1285884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2428860" y="1643050"/>
                  <a:ext cx="14287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2571736" y="2000240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2571736" y="2500330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18" name="TextBox 11"/>
                <p:cNvSpPr txBox="1"/>
                <p:nvPr/>
              </p:nvSpPr>
              <p:spPr>
                <a:xfrm>
                  <a:off x="2571736" y="3071834"/>
                  <a:ext cx="8572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571736" y="3571900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571736" y="4143404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714348" y="642918"/>
              <a:ext cx="29289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 3D 2020.3.4</a:t>
              </a:r>
              <a:endParaRPr lang="zh-CN" alt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 rot="18900000">
              <a:off x="2940627" y="2256772"/>
              <a:ext cx="7858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 rot="18900000">
              <a:off x="3782565" y="2163636"/>
              <a:ext cx="928694" cy="3744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Azo</a:t>
              </a:r>
              <a:r>
                <a:rPr lang="en-US" altLang="zh-CN" dirty="0"/>
                <a:t> 20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4030110" y="1982038"/>
              <a:ext cx="1500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zo20+Cd20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3392831" y="2256772"/>
              <a:ext cx="7143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d20</a:t>
              </a:r>
              <a:endParaRPr lang="zh-CN" altLang="en-US" dirty="0"/>
            </a:p>
          </p:txBody>
        </p:sp>
      </p:grp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2A1461BF-E6B4-4777-BED6-E9AE0306E16C}"/>
              </a:ext>
            </a:extLst>
          </p:cNvPr>
          <p:cNvCxnSpPr/>
          <p:nvPr/>
        </p:nvCxnSpPr>
        <p:spPr>
          <a:xfrm flipH="1">
            <a:off x="7170140" y="2996255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57D2E2FD-C756-4654-B59E-EDAD663CF6E0}"/>
              </a:ext>
            </a:extLst>
          </p:cNvPr>
          <p:cNvSpPr txBox="1"/>
          <p:nvPr/>
        </p:nvSpPr>
        <p:spPr>
          <a:xfrm>
            <a:off x="7464867" y="2811589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FA623D9D-E19C-4586-8AE3-8FE7315A84B8}"/>
              </a:ext>
            </a:extLst>
          </p:cNvPr>
          <p:cNvCxnSpPr/>
          <p:nvPr/>
        </p:nvCxnSpPr>
        <p:spPr>
          <a:xfrm flipH="1">
            <a:off x="7170452" y="521868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C202155E-FE83-4AD6-A4AB-AC91B2EEA63C}"/>
              </a:ext>
            </a:extLst>
          </p:cNvPr>
          <p:cNvSpPr txBox="1"/>
          <p:nvPr/>
        </p:nvSpPr>
        <p:spPr>
          <a:xfrm>
            <a:off x="7431929" y="508958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57356" y="2786058"/>
            <a:ext cx="4669200" cy="1208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833576" y="1619242"/>
            <a:ext cx="4667250" cy="666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857356" y="2285992"/>
            <a:ext cx="4669200" cy="529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831626" y="4000504"/>
            <a:ext cx="4669200" cy="1480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矩形 5"/>
          <p:cNvSpPr/>
          <p:nvPr/>
        </p:nvSpPr>
        <p:spPr>
          <a:xfrm>
            <a:off x="1785918" y="785794"/>
            <a:ext cx="20810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D  2023.9.29 1 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624825" y="185736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6793921" y="164305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6846123" y="3286124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631809" y="351258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-2700000">
            <a:off x="3728516" y="112993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4074709" y="95466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4469354" y="1047373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855507" y="845315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071538" y="178592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071538" y="214311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142976" y="235743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142976" y="271462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1142976" y="3071810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1142976" y="448842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1137495" y="384548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1137495" y="350043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1020477" y="1643050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85786" y="2532149"/>
            <a:ext cx="3960000" cy="31114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628" y="3214686"/>
            <a:ext cx="3960000" cy="10507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矩形 3"/>
          <p:cNvSpPr/>
          <p:nvPr/>
        </p:nvSpPr>
        <p:spPr>
          <a:xfrm>
            <a:off x="857224" y="714356"/>
            <a:ext cx="18582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D  2023.10.1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 rot="-2700000">
            <a:off x="2622419" y="201464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2968613" y="183955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3369259" y="193166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3603888" y="1744759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 rot="-2700000">
            <a:off x="1036145" y="2048449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 rot="-2700000">
            <a:off x="1290227" y="1877074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1673029" y="196010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1943091" y="1758049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0" y="263104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1061" y="292893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22499" y="314324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22499" y="335756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22499" y="364331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22499" y="485776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117018" y="421481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117018" y="400050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0" y="270247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857752" y="27146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072066" y="2500306"/>
            <a:ext cx="849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24" name="矩形 23"/>
          <p:cNvSpPr/>
          <p:nvPr/>
        </p:nvSpPr>
        <p:spPr>
          <a:xfrm>
            <a:off x="5357818" y="3357562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6" name="矩形 25"/>
          <p:cNvSpPr/>
          <p:nvPr/>
        </p:nvSpPr>
        <p:spPr>
          <a:xfrm>
            <a:off x="5072066" y="2928934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7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4792438" y="3494314"/>
            <a:ext cx="143500" cy="58437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3108" y="1643050"/>
            <a:ext cx="2352675" cy="800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43108" y="2428868"/>
            <a:ext cx="2354400" cy="691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3108" y="3143248"/>
            <a:ext cx="2354400" cy="1004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72066" y="3071810"/>
            <a:ext cx="2354400" cy="10090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143108" y="4071942"/>
            <a:ext cx="2354400" cy="19488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矩形 6"/>
          <p:cNvSpPr/>
          <p:nvPr/>
        </p:nvSpPr>
        <p:spPr>
          <a:xfrm>
            <a:off x="1357290" y="285728"/>
            <a:ext cx="18582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D  2023.10.3</a:t>
            </a:r>
            <a:endParaRPr lang="zh-CN" altLang="en-US" dirty="0"/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643438" y="185736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4929190" y="1714488"/>
            <a:ext cx="849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7715272" y="3571876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4857752" y="271462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1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4721000" y="3351438"/>
            <a:ext cx="143500" cy="58437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TextBox 12"/>
          <p:cNvSpPr txBox="1"/>
          <p:nvPr/>
        </p:nvSpPr>
        <p:spPr>
          <a:xfrm>
            <a:off x="1285852" y="185736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285852" y="214311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357290" y="2488164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357290" y="285749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357290" y="328612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357290" y="477418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1280371" y="408408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1351809" y="370261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1285852" y="171448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2583967" y="1098581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3035523" y="901121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3463257" y="103972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3732245" y="82935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500958" y="378619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285852" y="1643050"/>
            <a:ext cx="4486275" cy="277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1000100" y="285728"/>
            <a:ext cx="19447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E  2023.10.21</a:t>
            </a:r>
            <a:endParaRPr lang="zh-CN" altLang="en-US" dirty="0"/>
          </a:p>
        </p:txBody>
      </p:sp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85852" y="4929198"/>
            <a:ext cx="4485600" cy="9024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857884" y="28574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6072198" y="2643182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3286116" y="450057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8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2857488" y="3071810"/>
            <a:ext cx="291877" cy="214314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6072198" y="5131370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857884" y="534568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-2700000">
            <a:off x="3164863" y="1191041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3474832" y="102569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879388" y="111204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234147" y="940281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3214678" y="2786058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434077" y="170234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505515" y="192880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505515" y="22859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505515" y="257174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28596" y="178592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428596" y="401264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500034" y="292893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4" name="矩形 23"/>
          <p:cNvSpPr/>
          <p:nvPr/>
        </p:nvSpPr>
        <p:spPr>
          <a:xfrm>
            <a:off x="494553" y="321468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285852" y="1000108"/>
            <a:ext cx="1997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E  2023.10.24 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3019045" y="1444089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3374460" y="1274094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788228" y="137272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090525" y="1247328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000100" y="1928802"/>
            <a:ext cx="4686300" cy="2400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715008" y="292893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929322" y="2714620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5929322" y="5202808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715008" y="541712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矩形 19"/>
          <p:cNvSpPr/>
          <p:nvPr/>
        </p:nvSpPr>
        <p:spPr>
          <a:xfrm>
            <a:off x="3071802" y="2857496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3143240" y="4429132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071538" y="4929198"/>
            <a:ext cx="4581525" cy="771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2857488" y="3143248"/>
            <a:ext cx="214314" cy="200026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785918" y="2428868"/>
            <a:ext cx="4181475" cy="2390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1071538" y="571480"/>
            <a:ext cx="21146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E  2023.10.24 2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000100" y="255960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71538" y="264318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071538" y="29167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071538" y="314324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994619" y="444127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1000100" y="350043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1000100" y="241672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2176826" y="197682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2523018" y="181447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953387" y="188439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3203390" y="1710520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1000100" y="371475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2214546" y="3274270"/>
            <a:ext cx="1637374" cy="309748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072198" y="342900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6286512" y="3214686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6286512" y="5345684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6072198" y="555999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4214810" y="485776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857356" y="5286388"/>
            <a:ext cx="4200525" cy="790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3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3929058" y="3714752"/>
            <a:ext cx="214314" cy="178595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PARR1 GAPDH LC3B-M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28596" y="1571612"/>
            <a:ext cx="4320000" cy="3218823"/>
          </a:xfrm>
          <a:prstGeom prst="rect">
            <a:avLst/>
          </a:prstGeom>
        </p:spPr>
      </p:pic>
      <p:pic>
        <p:nvPicPr>
          <p:cNvPr id="3" name="图片 2" descr="GAPDH-cf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24000" y="1785926"/>
            <a:ext cx="4320000" cy="321882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571472" y="500042"/>
            <a:ext cx="18036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2C 2023.9.7-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85720" y="2453010"/>
            <a:ext cx="1143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170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7158" y="2571744"/>
            <a:ext cx="100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130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7158" y="2738762"/>
            <a:ext cx="14287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100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8596" y="2928934"/>
            <a:ext cx="12144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70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28596" y="3071810"/>
            <a:ext cx="9286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55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57158" y="3310266"/>
            <a:ext cx="8572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40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7158" y="3571876"/>
            <a:ext cx="100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35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7158" y="3738894"/>
            <a:ext cx="1000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25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7158" y="4167522"/>
            <a:ext cx="1143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chemeClr val="bg1"/>
                </a:solidFill>
              </a:rPr>
              <a:t>15KDa-</a:t>
            </a:r>
            <a:endParaRPr lang="zh-CN" altLang="en-US" sz="1100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 rot="-2700000">
            <a:off x="911981" y="200864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Con.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 rot="-2700000">
            <a:off x="1158280" y="186389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Cd20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 rot="-2700000">
            <a:off x="1465634" y="197991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solidFill>
                  <a:schemeClr val="bg1"/>
                </a:solidFill>
              </a:rPr>
              <a:t>Azo</a:t>
            </a:r>
            <a:r>
              <a:rPr lang="en-US" altLang="zh-CN" dirty="0">
                <a:solidFill>
                  <a:schemeClr val="bg1"/>
                </a:solidFill>
              </a:rPr>
              <a:t> 20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 rot="-2700000">
            <a:off x="1720762" y="176152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Azo20+Cd20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786314" y="3714752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5429256" y="3000372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1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4863876" y="3208562"/>
            <a:ext cx="143500" cy="58437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716573" y="27146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4978050" y="2488164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9B0BF4A5-F613-4319-A74A-A145EC251EC9}"/>
              </a:ext>
            </a:extLst>
          </p:cNvPr>
          <p:cNvCxnSpPr/>
          <p:nvPr/>
        </p:nvCxnSpPr>
        <p:spPr>
          <a:xfrm flipH="1">
            <a:off x="4714876" y="28574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4976353" y="2702478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714480" y="2071678"/>
            <a:ext cx="2819400" cy="350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1000100" y="500042"/>
            <a:ext cx="19912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F  2023.10.18 </a:t>
            </a:r>
            <a:endParaRPr lang="zh-CN" altLang="en-US" dirty="0"/>
          </a:p>
        </p:txBody>
      </p:sp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4786322"/>
            <a:ext cx="2676525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857224" y="228599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928662" y="277391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28662" y="305966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928662" y="3345420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57224" y="255960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851743" y="459629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928662" y="371475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928662" y="400050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857224" y="220241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016208" y="152952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2323601" y="132840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2787189" y="1456233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3089485" y="124535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500562" y="378619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4714876" y="3571876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8143900" y="5143512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929586" y="535782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5214942" y="4357694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2143108" y="3643314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5143504" y="3143248"/>
            <a:ext cx="571503" cy="2000264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2844" y="213097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14282" y="235743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85720" y="271462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85720" y="305966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42844" y="198884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208801" y="463130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280239" y="342900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280239" y="377404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1381803" y="133794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1678665" y="1248277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2133414" y="133305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457795" y="119739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143768" y="33454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7358082" y="3131106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7417627" y="5500702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203313" y="571501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/>
          <p:cNvSpPr/>
          <p:nvPr/>
        </p:nvSpPr>
        <p:spPr>
          <a:xfrm>
            <a:off x="3643306" y="5072074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071538" y="1928802"/>
            <a:ext cx="5991225" cy="3067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矩形 20"/>
          <p:cNvSpPr/>
          <p:nvPr/>
        </p:nvSpPr>
        <p:spPr>
          <a:xfrm>
            <a:off x="285720" y="285728"/>
            <a:ext cx="21611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F  2023.10.21 2 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3377776" y="1383568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3737239" y="118074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4061725" y="131524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4396110" y="1071579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071538" y="5429264"/>
            <a:ext cx="6076950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矩形 26"/>
          <p:cNvSpPr/>
          <p:nvPr/>
        </p:nvSpPr>
        <p:spPr>
          <a:xfrm>
            <a:off x="1428728" y="3286124"/>
            <a:ext cx="3643338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2714611" y="3714752"/>
            <a:ext cx="291877" cy="192882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57224" y="178592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000100" y="2214554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000100" y="250030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00100" y="285749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857224" y="200024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1066057" y="427411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994619" y="321468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994619" y="364331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857224" y="1643050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3559636" y="1095267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3880591" y="90324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4291726" y="102809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657033" y="800064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286644" y="321468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7572396" y="3000372"/>
            <a:ext cx="164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eIF2</a:t>
            </a:r>
            <a:r>
              <a:rPr lang="el-GR" altLang="zh-CN" dirty="0"/>
              <a:t>α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7643834" y="5500702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429520" y="571501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/>
          <p:cNvSpPr/>
          <p:nvPr/>
        </p:nvSpPr>
        <p:spPr>
          <a:xfrm>
            <a:off x="3143240" y="4643446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214282" y="142852"/>
            <a:ext cx="19912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F  2023.10.27 </a:t>
            </a:r>
            <a:endParaRPr lang="zh-CN" altLang="en-US" dirty="0"/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15206" y="2786058"/>
            <a:ext cx="5400000" cy="9646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85918" y="1643050"/>
            <a:ext cx="5400000" cy="1159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928794" y="5143512"/>
            <a:ext cx="5400000" cy="10119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34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857356" y="3786190"/>
            <a:ext cx="5436000" cy="7900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2928926" y="3500438"/>
            <a:ext cx="291877" cy="192882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3714744" y="3143248"/>
            <a:ext cx="1571636" cy="285752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67544" y="83394"/>
            <a:ext cx="7974626" cy="5289822"/>
            <a:chOff x="500034" y="925206"/>
            <a:chExt cx="7974626" cy="5289822"/>
          </a:xfrm>
        </p:grpSpPr>
        <p:grpSp>
          <p:nvGrpSpPr>
            <p:cNvPr id="3" name="组合 1"/>
            <p:cNvGrpSpPr/>
            <p:nvPr/>
          </p:nvGrpSpPr>
          <p:grpSpPr>
            <a:xfrm>
              <a:off x="642910" y="1714488"/>
              <a:ext cx="7429552" cy="4500540"/>
              <a:chOff x="500034" y="3128962"/>
              <a:chExt cx="7429552" cy="4500540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552575" y="3128962"/>
                <a:ext cx="6238800" cy="619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1571604" y="3786190"/>
                <a:ext cx="6238800" cy="10590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1485586" y="4857759"/>
                <a:ext cx="6444000" cy="13167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2" name="Picture 5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1476396" y="6134100"/>
                <a:ext cx="6444000" cy="14954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3" name="组合 19"/>
              <p:cNvGrpSpPr/>
              <p:nvPr/>
            </p:nvGrpSpPr>
            <p:grpSpPr>
              <a:xfrm>
                <a:off x="500034" y="3143247"/>
                <a:ext cx="1500198" cy="3922298"/>
                <a:chOff x="2143108" y="928670"/>
                <a:chExt cx="1500198" cy="2936743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2143108" y="928670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2143108" y="1214422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2214546" y="1463547"/>
                  <a:ext cx="14287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2285984" y="1730986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285984" y="2051912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19" name="TextBox 12"/>
                <p:cNvSpPr txBox="1"/>
                <p:nvPr/>
              </p:nvSpPr>
              <p:spPr>
                <a:xfrm>
                  <a:off x="2285984" y="2479815"/>
                  <a:ext cx="8572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285984" y="2800741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285984" y="3121668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285984" y="3496081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5KDa-</a:t>
                  </a:r>
                  <a:endParaRPr lang="zh-CN" altLang="en-US" dirty="0"/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500034" y="925206"/>
              <a:ext cx="2532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4C 2020.1.14</a:t>
              </a:r>
              <a:endParaRPr lang="zh-CN" alt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 rot="18900000">
              <a:off x="5888218" y="1202992"/>
              <a:ext cx="7858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 rot="18900000">
              <a:off x="6582799" y="1187678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Azo</a:t>
              </a:r>
              <a:r>
                <a:rPr lang="en-US" altLang="zh-CN" dirty="0"/>
                <a:t> 20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6250184" y="1257984"/>
              <a:ext cx="7143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d20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6974462" y="1062828"/>
              <a:ext cx="1500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zo20+Cd20</a:t>
              </a:r>
              <a:endParaRPr lang="zh-CN" altLang="en-US" dirty="0"/>
            </a:p>
          </p:txBody>
        </p:sp>
      </p:grpSp>
      <p:pic>
        <p:nvPicPr>
          <p:cNvPr id="23" name="图片 22">
            <a:extLst>
              <a:ext uri="{FF2B5EF4-FFF2-40B4-BE49-F238E27FC236}">
                <a16:creationId xmlns:a16="http://schemas.microsoft.com/office/drawing/2014/main" id="{9DE2EB27-11B0-4AE8-9B00-C75EF26AF8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53428" y="5433095"/>
            <a:ext cx="6286544" cy="1333509"/>
          </a:xfrm>
          <a:prstGeom prst="rect">
            <a:avLst/>
          </a:prstGeom>
        </p:spPr>
      </p:pic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8013374" y="615038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8274851" y="602128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7936170" y="15990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8197647" y="1469996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0" y="557214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30" name="箭头: 下 24">
            <a:extLst>
              <a:ext uri="{FF2B5EF4-FFF2-40B4-BE49-F238E27FC236}">
                <a16:creationId xmlns:a16="http://schemas.microsoft.com/office/drawing/2014/main" id="{DD53A253-A891-40BC-B938-32162B3AB8D8}"/>
              </a:ext>
            </a:extLst>
          </p:cNvPr>
          <p:cNvSpPr/>
          <p:nvPr/>
        </p:nvSpPr>
        <p:spPr>
          <a:xfrm>
            <a:off x="5000628" y="3286124"/>
            <a:ext cx="121031" cy="265375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71604" y="1428736"/>
            <a:ext cx="4210050" cy="3857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71603" y="5514974"/>
            <a:ext cx="4212000" cy="1346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5863650" y="654635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6125127" y="641725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5786446" y="191502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6047923" y="1785926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785786" y="285728"/>
            <a:ext cx="19559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4C 2023.10.3 1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19829" y="207167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19829" y="235743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19829" y="278605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19829" y="414338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708867" y="350043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714348" y="321468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6000760" y="5572140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19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786182" y="3214686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3529376" y="88095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 rot="-2700000">
            <a:off x="3892991" y="76605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4346833" y="83043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4652221" y="67273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1925225" y="950239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2337938" y="76605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 rot="-2700000">
            <a:off x="2744078" y="88612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 rot="-2700000">
            <a:off x="3006160" y="62538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2000232" y="1785926"/>
            <a:ext cx="3143272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357298"/>
            <a:ext cx="6010275" cy="3638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5505471"/>
            <a:ext cx="5981700" cy="923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矩形 3"/>
          <p:cNvSpPr/>
          <p:nvPr/>
        </p:nvSpPr>
        <p:spPr>
          <a:xfrm>
            <a:off x="500034" y="285728"/>
            <a:ext cx="2428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 4D 2023.10.1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9829" y="200024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829" y="22859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9829" y="2631040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19829" y="392906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708867" y="321468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714348" y="300037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7643834" y="607220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7858148" y="591718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7572396" y="171448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7858148" y="150017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4214810" y="5072074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19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786182" y="3000372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3857620" y="1643050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0"/>
          <p:cNvSpPr txBox="1"/>
          <p:nvPr/>
        </p:nvSpPr>
        <p:spPr>
          <a:xfrm rot="-2700000">
            <a:off x="3861704" y="831607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4210308" y="610001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4579574" y="73345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4979895" y="519510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095386"/>
            <a:ext cx="4581525" cy="3905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500034" y="285728"/>
            <a:ext cx="264320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 4D  2023.10.3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8391" y="128586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48391" y="1559470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19829" y="1857364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9829" y="213097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829" y="2559602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9829" y="398836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708867" y="328612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714348" y="298823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648391" y="1142984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801664" y="58515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129498" y="39970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4566575" y="53463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4906819" y="332581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6286512" y="650083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6500826" y="628652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6143636" y="157161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6429388" y="1357298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5366288"/>
            <a:ext cx="4572000" cy="1491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071802" y="3071810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3500430" y="5000636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3857620" y="1500174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00034" y="285728"/>
            <a:ext cx="19223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4D 2023.10.14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19829" y="200024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19829" y="221455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9829" y="257174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829" y="371475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708867" y="307181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714348" y="291679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2254998" y="648989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2668803" y="53552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3046596" y="61994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3437146" y="40351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214422"/>
            <a:ext cx="4734265" cy="34290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5429264"/>
            <a:ext cx="4734000" cy="865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6286512" y="60007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6500826" y="585789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6143636" y="164305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6429388" y="1488032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071802" y="2857496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500430" y="5000636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4" name="矩形 23"/>
          <p:cNvSpPr/>
          <p:nvPr/>
        </p:nvSpPr>
        <p:spPr>
          <a:xfrm>
            <a:off x="2357422" y="1714488"/>
            <a:ext cx="1571636" cy="214314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67544" y="83394"/>
            <a:ext cx="7974626" cy="5289822"/>
            <a:chOff x="500034" y="925206"/>
            <a:chExt cx="7974626" cy="5289822"/>
          </a:xfrm>
        </p:grpSpPr>
        <p:grpSp>
          <p:nvGrpSpPr>
            <p:cNvPr id="3" name="组合 1"/>
            <p:cNvGrpSpPr/>
            <p:nvPr/>
          </p:nvGrpSpPr>
          <p:grpSpPr>
            <a:xfrm>
              <a:off x="642910" y="1714488"/>
              <a:ext cx="7429552" cy="4500540"/>
              <a:chOff x="500034" y="3128962"/>
              <a:chExt cx="7429552" cy="4500540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552575" y="3128962"/>
                <a:ext cx="6238800" cy="619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1571604" y="3786190"/>
                <a:ext cx="6238800" cy="10590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1485586" y="4857759"/>
                <a:ext cx="6444000" cy="13167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2" name="Picture 5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1476396" y="6134100"/>
                <a:ext cx="6444000" cy="14954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3" name="组合 19"/>
              <p:cNvGrpSpPr/>
              <p:nvPr/>
            </p:nvGrpSpPr>
            <p:grpSpPr>
              <a:xfrm>
                <a:off x="500034" y="3143247"/>
                <a:ext cx="1500198" cy="3922298"/>
                <a:chOff x="2143108" y="928670"/>
                <a:chExt cx="1500198" cy="2936743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2143108" y="928670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2143108" y="1214422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2214546" y="1463547"/>
                  <a:ext cx="14287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2285984" y="1730986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285984" y="2051912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19" name="TextBox 12"/>
                <p:cNvSpPr txBox="1"/>
                <p:nvPr/>
              </p:nvSpPr>
              <p:spPr>
                <a:xfrm>
                  <a:off x="2285984" y="2479815"/>
                  <a:ext cx="8572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285984" y="2800741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285984" y="3121668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285984" y="3496081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5KDa-</a:t>
                  </a:r>
                  <a:endParaRPr lang="zh-CN" altLang="en-US" dirty="0"/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500034" y="925206"/>
              <a:ext cx="28185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5A 2020.3.11</a:t>
              </a:r>
              <a:endParaRPr lang="zh-CN" alt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 rot="18900000">
              <a:off x="5888218" y="1202992"/>
              <a:ext cx="7858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 rot="18900000">
              <a:off x="6582799" y="1187678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Azo</a:t>
              </a:r>
              <a:r>
                <a:rPr lang="en-US" altLang="zh-CN" dirty="0"/>
                <a:t> 20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6250184" y="1257984"/>
              <a:ext cx="7143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d20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6974462" y="1062828"/>
              <a:ext cx="1500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zo20+Cd20</a:t>
              </a:r>
              <a:endParaRPr lang="zh-CN" altLang="en-US" dirty="0"/>
            </a:p>
          </p:txBody>
        </p:sp>
      </p:grpSp>
      <p:pic>
        <p:nvPicPr>
          <p:cNvPr id="23" name="图片 22">
            <a:extLst>
              <a:ext uri="{FF2B5EF4-FFF2-40B4-BE49-F238E27FC236}">
                <a16:creationId xmlns:a16="http://schemas.microsoft.com/office/drawing/2014/main" id="{9DE2EB27-11B0-4AE8-9B00-C75EF26AF8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53428" y="5433095"/>
            <a:ext cx="6286544" cy="1333509"/>
          </a:xfrm>
          <a:prstGeom prst="rect">
            <a:avLst/>
          </a:prstGeom>
        </p:spPr>
      </p:pic>
      <p:sp>
        <p:nvSpPr>
          <p:cNvPr id="24" name="箭头: 下 24">
            <a:extLst>
              <a:ext uri="{FF2B5EF4-FFF2-40B4-BE49-F238E27FC236}">
                <a16:creationId xmlns:a16="http://schemas.microsoft.com/office/drawing/2014/main" id="{DD53A253-A891-40BC-B938-32162B3AB8D8}"/>
              </a:ext>
            </a:extLst>
          </p:cNvPr>
          <p:cNvSpPr/>
          <p:nvPr/>
        </p:nvSpPr>
        <p:spPr>
          <a:xfrm>
            <a:off x="4932040" y="3130201"/>
            <a:ext cx="121031" cy="265375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TextBox 4">
            <a:extLst>
              <a:ext uri="{FF2B5EF4-FFF2-40B4-BE49-F238E27FC236}">
                <a16:creationId xmlns:a16="http://schemas.microsoft.com/office/drawing/2014/main" id="{2E8D72AA-0271-49EA-82D4-74C23AFE3418}"/>
              </a:ext>
            </a:extLst>
          </p:cNvPr>
          <p:cNvSpPr txBox="1"/>
          <p:nvPr/>
        </p:nvSpPr>
        <p:spPr>
          <a:xfrm>
            <a:off x="5064478" y="5433095"/>
            <a:ext cx="2643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8013374" y="615038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8274851" y="602128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20CCB0EC-15FF-4266-8F22-A7CC13BC903F}"/>
              </a:ext>
            </a:extLst>
          </p:cNvPr>
          <p:cNvCxnSpPr/>
          <p:nvPr/>
        </p:nvCxnSpPr>
        <p:spPr>
          <a:xfrm flipH="1">
            <a:off x="7884368" y="3144611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1">
            <a:extLst>
              <a:ext uri="{FF2B5EF4-FFF2-40B4-BE49-F238E27FC236}">
                <a16:creationId xmlns:a16="http://schemas.microsoft.com/office/drawing/2014/main" id="{5EFD7A18-D1A4-4772-980A-218C41C9450D}"/>
              </a:ext>
            </a:extLst>
          </p:cNvPr>
          <p:cNvSpPr txBox="1"/>
          <p:nvPr/>
        </p:nvSpPr>
        <p:spPr>
          <a:xfrm>
            <a:off x="8145845" y="3015511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571612"/>
            <a:ext cx="5067300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4542394"/>
            <a:ext cx="5112000" cy="1101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19829" y="205953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9829" y="234528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829" y="277391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708867" y="341685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714348" y="307181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4188910" y="1029757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4491926" y="813277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4906092" y="94786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5228992" y="72596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7" name="箭头: 下 24">
            <a:extLst>
              <a:ext uri="{FF2B5EF4-FFF2-40B4-BE49-F238E27FC236}">
                <a16:creationId xmlns:a16="http://schemas.microsoft.com/office/drawing/2014/main" id="{DD53A253-A891-40BC-B938-32162B3AB8D8}"/>
              </a:ext>
            </a:extLst>
          </p:cNvPr>
          <p:cNvSpPr/>
          <p:nvPr/>
        </p:nvSpPr>
        <p:spPr>
          <a:xfrm>
            <a:off x="4214810" y="3286124"/>
            <a:ext cx="142876" cy="157163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TextBox 4">
            <a:extLst>
              <a:ext uri="{FF2B5EF4-FFF2-40B4-BE49-F238E27FC236}">
                <a16:creationId xmlns:a16="http://schemas.microsoft.com/office/drawing/2014/main" id="{2E8D72AA-0271-49EA-82D4-74C23AFE3418}"/>
              </a:ext>
            </a:extLst>
          </p:cNvPr>
          <p:cNvSpPr txBox="1"/>
          <p:nvPr/>
        </p:nvSpPr>
        <p:spPr>
          <a:xfrm>
            <a:off x="4357686" y="4071942"/>
            <a:ext cx="2643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6786578" y="507207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7072330" y="485776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20CCB0EC-15FF-4266-8F22-A7CC13BC903F}"/>
              </a:ext>
            </a:extLst>
          </p:cNvPr>
          <p:cNvCxnSpPr/>
          <p:nvPr/>
        </p:nvCxnSpPr>
        <p:spPr>
          <a:xfrm flipH="1">
            <a:off x="6643702" y="307181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31">
            <a:extLst>
              <a:ext uri="{FF2B5EF4-FFF2-40B4-BE49-F238E27FC236}">
                <a16:creationId xmlns:a16="http://schemas.microsoft.com/office/drawing/2014/main" id="{5EFD7A18-D1A4-4772-980A-218C41C9450D}"/>
              </a:ext>
            </a:extLst>
          </p:cNvPr>
          <p:cNvSpPr txBox="1"/>
          <p:nvPr/>
        </p:nvSpPr>
        <p:spPr>
          <a:xfrm>
            <a:off x="6929454" y="2857496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785786" y="357166"/>
            <a:ext cx="17956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A 2023.9.18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348" y="4214818"/>
            <a:ext cx="5011200" cy="1523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14348" y="1928802"/>
            <a:ext cx="5010150" cy="819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14348" y="2714620"/>
            <a:ext cx="5011200" cy="14569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571472" y="285728"/>
            <a:ext cx="19207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2C 2023.9.27-1</a:t>
            </a:r>
          </a:p>
        </p:txBody>
      </p:sp>
      <p:sp>
        <p:nvSpPr>
          <p:cNvPr id="6" name="TextBox 5"/>
          <p:cNvSpPr txBox="1"/>
          <p:nvPr/>
        </p:nvSpPr>
        <p:spPr>
          <a:xfrm rot="-2700000">
            <a:off x="1149565" y="143463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1545688" y="125621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1934272" y="1358653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 rot="-2700000">
            <a:off x="2377809" y="118277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6072198" y="3429000"/>
            <a:ext cx="869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776250" y="214311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6037727" y="2000240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9B0BF4A5-F613-4319-A74A-A145EC251EC9}"/>
              </a:ext>
            </a:extLst>
          </p:cNvPr>
          <p:cNvCxnSpPr/>
          <p:nvPr/>
        </p:nvCxnSpPr>
        <p:spPr>
          <a:xfrm flipH="1">
            <a:off x="5831664" y="24288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6036030" y="2273850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9B0BF4A5-F613-4319-A74A-A145EC251EC9}"/>
              </a:ext>
            </a:extLst>
          </p:cNvPr>
          <p:cNvCxnSpPr/>
          <p:nvPr/>
        </p:nvCxnSpPr>
        <p:spPr>
          <a:xfrm flipH="1">
            <a:off x="5786446" y="364331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0" y="1857364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0" y="200024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0" y="220241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71438" y="250030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142876" y="278605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142876" y="314324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42876" y="357187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142876" y="392906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142876" y="464344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857224" y="428604"/>
            <a:ext cx="18485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A  2023.10.1</a:t>
            </a:r>
            <a:endParaRPr lang="zh-CN" altLang="en-US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428992" y="5786454"/>
            <a:ext cx="3600000" cy="9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 rot="-2700000">
            <a:off x="1443830" y="1677422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1744730" y="1471278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-2700000">
            <a:off x="2176525" y="154665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2429044" y="1344595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14414" y="2214553"/>
            <a:ext cx="3600000" cy="7768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14414" y="3071810"/>
            <a:ext cx="3672000" cy="88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214414" y="4000504"/>
            <a:ext cx="3708000" cy="14496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428596" y="228599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57158" y="242886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28596" y="271462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28596" y="300037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28596" y="328612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28596" y="450057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428596" y="392906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428596" y="364331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28596" y="213097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7072330" y="64293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143504" y="3286124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  <p:sp>
        <p:nvSpPr>
          <p:cNvPr id="23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7286644" y="627437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4" name="矩形 23"/>
          <p:cNvSpPr/>
          <p:nvPr/>
        </p:nvSpPr>
        <p:spPr>
          <a:xfrm>
            <a:off x="4643438" y="5429264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5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857620" y="3714752"/>
            <a:ext cx="285751" cy="228601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4929190" y="342900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19083" y="1643050"/>
            <a:ext cx="2352675" cy="413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928662" y="357166"/>
            <a:ext cx="17347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B 2023.9.27</a:t>
            </a:r>
            <a:endParaRPr lang="zh-CN" alt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786314" y="2571744"/>
            <a:ext cx="2200275" cy="1504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142844" y="1782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42844" y="205953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14282" y="242886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14282" y="270247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14282" y="305966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14282" y="450057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203320" y="378619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208801" y="348829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142844" y="1639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1279951" y="1105916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1674161" y="94506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2105555" y="103287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2480782" y="886879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3524705" y="313281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3786182" y="2928934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7000892" y="357187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286644" y="335756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 flipH="1">
            <a:off x="3714744" y="3000372"/>
            <a:ext cx="204823" cy="106207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4643438" y="2143116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3524705" y="291850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3786182" y="2714620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928662" y="357166"/>
            <a:ext cx="18517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B 2023.10.12</a:t>
            </a:r>
            <a:endParaRPr lang="zh-CN" alt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28727" y="2000239"/>
            <a:ext cx="4039200" cy="11387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428728" y="3143248"/>
            <a:ext cx="4038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28728" y="5000635"/>
            <a:ext cx="4075200" cy="7529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428728" y="3603968"/>
            <a:ext cx="4075200" cy="760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571472" y="207167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71472" y="228599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42910" y="2571744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42910" y="285749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42910" y="328612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31948" y="407525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637429" y="377736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571472" y="192880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1750025" y="144190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2054629" y="1270047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2449028" y="137314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2816169" y="1165065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572132" y="520280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857884" y="498849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flipH="1">
            <a:off x="3000364" y="4214818"/>
            <a:ext cx="214314" cy="9286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214678" y="4500570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500694" y="347786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762171" y="3273982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500694" y="320425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762171" y="3000372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 rot="-2700000">
            <a:off x="3288038" y="1452752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9" name="TextBox 28"/>
          <p:cNvSpPr txBox="1"/>
          <p:nvPr/>
        </p:nvSpPr>
        <p:spPr>
          <a:xfrm rot="-2700000">
            <a:off x="3541637" y="131260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30" name="TextBox 29"/>
          <p:cNvSpPr txBox="1"/>
          <p:nvPr/>
        </p:nvSpPr>
        <p:spPr>
          <a:xfrm rot="-2700000">
            <a:off x="3942137" y="138528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 rot="-2700000">
            <a:off x="4340042" y="116506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42910" y="357166"/>
            <a:ext cx="264320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 5C  2023.9.23</a:t>
            </a:r>
            <a:endParaRPr lang="zh-CN" alt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28860" y="1214422"/>
            <a:ext cx="2562225" cy="4257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357818" y="4071942"/>
            <a:ext cx="2371725" cy="138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1500166" y="114298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500166" y="1285860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643042" y="163090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500166" y="227385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500166" y="270247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571604" y="514351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1571604" y="421481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1566123" y="328612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617844" y="67408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2999755" y="471147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3440393" y="59050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3927500" y="37101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5214942" y="300037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4">
            <a:extLst>
              <a:ext uri="{FF2B5EF4-FFF2-40B4-BE49-F238E27FC236}">
                <a16:creationId xmlns:a16="http://schemas.microsoft.com/office/drawing/2014/main" id="{BCF67A44-06AB-4B2F-83DA-5DE6497C8F81}"/>
              </a:ext>
            </a:extLst>
          </p:cNvPr>
          <p:cNvSpPr txBox="1"/>
          <p:nvPr/>
        </p:nvSpPr>
        <p:spPr>
          <a:xfrm>
            <a:off x="5429256" y="2786058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E3BF80-8DBB-4CC2-BAE4-5C1E60588A4D}"/>
              </a:ext>
            </a:extLst>
          </p:cNvPr>
          <p:cNvSpPr txBox="1"/>
          <p:nvPr/>
        </p:nvSpPr>
        <p:spPr>
          <a:xfrm>
            <a:off x="5214942" y="3643314"/>
            <a:ext cx="372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2" name="文本框 28">
            <a:extLst>
              <a:ext uri="{FF2B5EF4-FFF2-40B4-BE49-F238E27FC236}">
                <a16:creationId xmlns:a16="http://schemas.microsoft.com/office/drawing/2014/main" id="{31AFBCE6-23B7-4C2A-91BD-F9BAA6BD22D9}"/>
              </a:ext>
            </a:extLst>
          </p:cNvPr>
          <p:cNvSpPr txBox="1"/>
          <p:nvPr/>
        </p:nvSpPr>
        <p:spPr>
          <a:xfrm>
            <a:off x="8072462" y="492919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1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5607850" y="2750340"/>
            <a:ext cx="428630" cy="1357322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7858148" y="514351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42910" y="357166"/>
            <a:ext cx="18389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C  2023.9.27</a:t>
            </a:r>
            <a:endParaRPr lang="zh-CN" altLang="en-US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8774" y="1571612"/>
            <a:ext cx="4686300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448175" y="5495925"/>
            <a:ext cx="4695825" cy="1362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535074" y="2500306"/>
            <a:ext cx="4680000" cy="13718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8" name="Picture 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571604" y="3857627"/>
            <a:ext cx="4680000" cy="1573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7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19829" y="205953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19829" y="248816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19829" y="284535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19829" y="434555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708867" y="3559734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714348" y="327398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2069513" y="102695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2367442" y="84204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2794254" y="96013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3136427" y="70828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6313301" y="30596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4">
            <a:extLst>
              <a:ext uri="{FF2B5EF4-FFF2-40B4-BE49-F238E27FC236}">
                <a16:creationId xmlns:a16="http://schemas.microsoft.com/office/drawing/2014/main" id="{BCF67A44-06AB-4B2F-83DA-5DE6497C8F81}"/>
              </a:ext>
            </a:extLst>
          </p:cNvPr>
          <p:cNvSpPr txBox="1"/>
          <p:nvPr/>
        </p:nvSpPr>
        <p:spPr>
          <a:xfrm>
            <a:off x="6527615" y="2845354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E3BF80-8DBB-4CC2-BAE4-5C1E60588A4D}"/>
              </a:ext>
            </a:extLst>
          </p:cNvPr>
          <p:cNvSpPr txBox="1"/>
          <p:nvPr/>
        </p:nvSpPr>
        <p:spPr>
          <a:xfrm>
            <a:off x="6286512" y="5072074"/>
            <a:ext cx="372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4" name="文本框 28">
            <a:extLst>
              <a:ext uri="{FF2B5EF4-FFF2-40B4-BE49-F238E27FC236}">
                <a16:creationId xmlns:a16="http://schemas.microsoft.com/office/drawing/2014/main" id="{31AFBCE6-23B7-4C2A-91BD-F9BAA6BD22D9}"/>
              </a:ext>
            </a:extLst>
          </p:cNvPr>
          <p:cNvSpPr txBox="1"/>
          <p:nvPr/>
        </p:nvSpPr>
        <p:spPr>
          <a:xfrm>
            <a:off x="3143240" y="614364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5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6500826" y="3143248"/>
            <a:ext cx="1000132" cy="1571636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>
            <a:off x="4071934" y="6357958"/>
            <a:ext cx="473846" cy="15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80136" y="63759"/>
            <a:ext cx="18389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C  2023.10.1</a:t>
            </a:r>
            <a:endParaRPr lang="zh-CN" altLang="en-US" dirty="0"/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6596539" y="262940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24">
            <a:extLst>
              <a:ext uri="{FF2B5EF4-FFF2-40B4-BE49-F238E27FC236}">
                <a16:creationId xmlns:a16="http://schemas.microsoft.com/office/drawing/2014/main" id="{BCF67A44-06AB-4B2F-83DA-5DE6497C8F81}"/>
              </a:ext>
            </a:extLst>
          </p:cNvPr>
          <p:cNvSpPr txBox="1"/>
          <p:nvPr/>
        </p:nvSpPr>
        <p:spPr>
          <a:xfrm>
            <a:off x="6858016" y="2428868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38</a:t>
            </a:r>
            <a:endParaRPr lang="zh-CN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4E3BF80-8DBB-4CC2-BAE4-5C1E60588A4D}"/>
              </a:ext>
            </a:extLst>
          </p:cNvPr>
          <p:cNvSpPr txBox="1"/>
          <p:nvPr/>
        </p:nvSpPr>
        <p:spPr>
          <a:xfrm>
            <a:off x="4143372" y="5072074"/>
            <a:ext cx="372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92D19BEB-B72D-4D11-8297-025FE8F2D49A}"/>
              </a:ext>
            </a:extLst>
          </p:cNvPr>
          <p:cNvCxnSpPr/>
          <p:nvPr/>
        </p:nvCxnSpPr>
        <p:spPr>
          <a:xfrm flipH="1">
            <a:off x="6593794" y="639974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28">
            <a:extLst>
              <a:ext uri="{FF2B5EF4-FFF2-40B4-BE49-F238E27FC236}">
                <a16:creationId xmlns:a16="http://schemas.microsoft.com/office/drawing/2014/main" id="{31AFBCE6-23B7-4C2A-91BD-F9BAA6BD22D9}"/>
              </a:ext>
            </a:extLst>
          </p:cNvPr>
          <p:cNvSpPr txBox="1"/>
          <p:nvPr/>
        </p:nvSpPr>
        <p:spPr>
          <a:xfrm>
            <a:off x="6858016" y="621508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71604" y="1071546"/>
            <a:ext cx="4943475" cy="3848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626426" y="5429264"/>
            <a:ext cx="4874400" cy="1315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箭头: 右 26">
            <a:extLst>
              <a:ext uri="{FF2B5EF4-FFF2-40B4-BE49-F238E27FC236}">
                <a16:creationId xmlns:a16="http://schemas.microsoft.com/office/drawing/2014/main" id="{AD72CFCC-34D5-47EF-AE35-28E6D4B05FA1}"/>
              </a:ext>
            </a:extLst>
          </p:cNvPr>
          <p:cNvSpPr/>
          <p:nvPr/>
        </p:nvSpPr>
        <p:spPr>
          <a:xfrm rot="5400000">
            <a:off x="2035949" y="4321976"/>
            <a:ext cx="2857521" cy="714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648391" y="128586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648391" y="150017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19829" y="178592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19829" y="207167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719829" y="248816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719829" y="392906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708867" y="314324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714348" y="285749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9" name="矩形 18"/>
          <p:cNvSpPr/>
          <p:nvPr/>
        </p:nvSpPr>
        <p:spPr>
          <a:xfrm>
            <a:off x="648391" y="1202280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1798150" y="595201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 rot="-2700000">
            <a:off x="2261142" y="35716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-2700000">
            <a:off x="2662160" y="45659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3115706" y="285374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3959192" y="503787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4313335" y="37515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 rot="-2700000">
            <a:off x="4831799" y="426643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 rot="-2700000">
            <a:off x="5207025" y="24468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14480" y="2071677"/>
            <a:ext cx="4500000" cy="5574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14480" y="2600322"/>
            <a:ext cx="4503600" cy="5473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714480" y="1357298"/>
            <a:ext cx="4476750" cy="695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714480" y="3165351"/>
            <a:ext cx="4500000" cy="8351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2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714480" y="4643446"/>
            <a:ext cx="4500000" cy="827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矩形 6"/>
          <p:cNvSpPr/>
          <p:nvPr/>
        </p:nvSpPr>
        <p:spPr>
          <a:xfrm>
            <a:off x="642910" y="357166"/>
            <a:ext cx="19752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D  2023.10.12</a:t>
            </a:r>
            <a:endParaRPr lang="zh-CN" altLang="en-US" dirty="0"/>
          </a:p>
        </p:txBody>
      </p:sp>
      <p:sp>
        <p:nvSpPr>
          <p:cNvPr id="8" name="文本框 24">
            <a:extLst>
              <a:ext uri="{FF2B5EF4-FFF2-40B4-BE49-F238E27FC236}">
                <a16:creationId xmlns:a16="http://schemas.microsoft.com/office/drawing/2014/main" id="{BCF67A44-06AB-4B2F-83DA-5DE6497C8F81}"/>
              </a:ext>
            </a:extLst>
          </p:cNvPr>
          <p:cNvSpPr txBox="1"/>
          <p:nvPr/>
        </p:nvSpPr>
        <p:spPr>
          <a:xfrm>
            <a:off x="6429388" y="2643182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E3BF80-8DBB-4CC2-BAE4-5C1E60588A4D}"/>
              </a:ext>
            </a:extLst>
          </p:cNvPr>
          <p:cNvSpPr txBox="1"/>
          <p:nvPr/>
        </p:nvSpPr>
        <p:spPr>
          <a:xfrm>
            <a:off x="3786182" y="4143380"/>
            <a:ext cx="372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10" name="文本框 28">
            <a:extLst>
              <a:ext uri="{FF2B5EF4-FFF2-40B4-BE49-F238E27FC236}">
                <a16:creationId xmlns:a16="http://schemas.microsoft.com/office/drawing/2014/main" id="{31AFBCE6-23B7-4C2A-91BD-F9BAA6BD22D9}"/>
              </a:ext>
            </a:extLst>
          </p:cNvPr>
          <p:cNvSpPr txBox="1"/>
          <p:nvPr/>
        </p:nvSpPr>
        <p:spPr>
          <a:xfrm>
            <a:off x="6488933" y="457200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6274619" y="478632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6215074" y="27146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018C0FB3-6F83-4BAF-B39F-C8752B1D0798}"/>
              </a:ext>
            </a:extLst>
          </p:cNvPr>
          <p:cNvCxnSpPr/>
          <p:nvPr/>
        </p:nvCxnSpPr>
        <p:spPr>
          <a:xfrm flipH="1">
            <a:off x="6215074" y="292893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714348" y="150017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785786" y="171448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928662" y="207167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928662" y="248816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928662" y="284535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923181" y="363117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923181" y="334542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734725" y="135729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2012464" y="88095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2463208" y="68442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 rot="-2700000">
            <a:off x="2870267" y="748971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 rot="-2700000">
            <a:off x="3183597" y="528267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28" name="箭头: 右 26">
            <a:extLst>
              <a:ext uri="{FF2B5EF4-FFF2-40B4-BE49-F238E27FC236}">
                <a16:creationId xmlns:a16="http://schemas.microsoft.com/office/drawing/2014/main" id="{AD72CFCC-34D5-47EF-AE35-28E6D4B05FA1}"/>
              </a:ext>
            </a:extLst>
          </p:cNvPr>
          <p:cNvSpPr/>
          <p:nvPr/>
        </p:nvSpPr>
        <p:spPr>
          <a:xfrm rot="5400000">
            <a:off x="891439" y="3841739"/>
            <a:ext cx="2000264" cy="1428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00034" y="285728"/>
            <a:ext cx="19223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D  2023.10.14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48391" y="157161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8391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19829" y="200024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19829" y="221455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9829" y="257174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829" y="371475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708867" y="307181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714348" y="291679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648391" y="142873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2202314" y="66666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019349" y="59949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214422"/>
            <a:ext cx="4734265" cy="34290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5429264"/>
            <a:ext cx="4734000" cy="865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6286512" y="60007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6500826" y="585789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6260292" y="250030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6429388" y="2416726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sp>
        <p:nvSpPr>
          <p:cNvPr id="20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1703666" y="2817985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3500430" y="5000636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6260292" y="278605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-2700000">
            <a:off x="2595376" y="499808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3409142" y="414091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00034" y="285728"/>
            <a:ext cx="18694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5D  2023.10.17</a:t>
            </a:r>
            <a:endParaRPr lang="zh-CN" altLang="en-US" dirty="0"/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42976" y="1357298"/>
            <a:ext cx="6124575" cy="3638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357290" y="5643578"/>
            <a:ext cx="6029325" cy="103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214282" y="142873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14282" y="170234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5720" y="198809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5720" y="227385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85720" y="2559602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5720" y="398836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274758" y="327398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280239" y="2988230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214282" y="1285860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1642323" y="809876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1952654" y="64797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2397595" y="74765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2713126" y="58309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62E29F24-F210-4FCA-8940-CBCE4FE4CFE6}"/>
              </a:ext>
            </a:extLst>
          </p:cNvPr>
          <p:cNvCxnSpPr/>
          <p:nvPr/>
        </p:nvCxnSpPr>
        <p:spPr>
          <a:xfrm flipH="1">
            <a:off x="7489065" y="620294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7">
            <a:extLst>
              <a:ext uri="{FF2B5EF4-FFF2-40B4-BE49-F238E27FC236}">
                <a16:creationId xmlns:a16="http://schemas.microsoft.com/office/drawing/2014/main" id="{6A86B9B1-CCA4-48EF-9E36-8B8E9AE3F50B}"/>
              </a:ext>
            </a:extLst>
          </p:cNvPr>
          <p:cNvSpPr txBox="1"/>
          <p:nvPr/>
        </p:nvSpPr>
        <p:spPr>
          <a:xfrm>
            <a:off x="7703379" y="60600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7358082" y="257174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9">
            <a:extLst>
              <a:ext uri="{FF2B5EF4-FFF2-40B4-BE49-F238E27FC236}">
                <a16:creationId xmlns:a16="http://schemas.microsoft.com/office/drawing/2014/main" id="{F4584E10-B6D6-40D3-B6D9-43C5355A0FA0}"/>
              </a:ext>
            </a:extLst>
          </p:cNvPr>
          <p:cNvSpPr txBox="1"/>
          <p:nvPr/>
        </p:nvSpPr>
        <p:spPr>
          <a:xfrm>
            <a:off x="7527178" y="2428868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JNK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1137495" y="3124067"/>
            <a:ext cx="292501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1488585" y="5110578"/>
            <a:ext cx="244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50D752BD-3AE0-47A9-B946-BB411961167C}"/>
              </a:ext>
            </a:extLst>
          </p:cNvPr>
          <p:cNvCxnSpPr/>
          <p:nvPr/>
        </p:nvCxnSpPr>
        <p:spPr>
          <a:xfrm flipH="1">
            <a:off x="7358082" y="279820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42910" y="571480"/>
            <a:ext cx="17219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E 2020.9.22</a:t>
            </a:r>
            <a:endParaRPr lang="zh-CN" altLang="en-US" dirty="0"/>
          </a:p>
        </p:txBody>
      </p:sp>
      <p:grpSp>
        <p:nvGrpSpPr>
          <p:cNvPr id="3" name="组合 2"/>
          <p:cNvGrpSpPr/>
          <p:nvPr/>
        </p:nvGrpSpPr>
        <p:grpSpPr>
          <a:xfrm>
            <a:off x="1547664" y="1268760"/>
            <a:ext cx="4024319" cy="3651971"/>
            <a:chOff x="714348" y="2494284"/>
            <a:chExt cx="4024319" cy="3651971"/>
          </a:xfrm>
        </p:grpSpPr>
        <p:grpSp>
          <p:nvGrpSpPr>
            <p:cNvPr id="4" name="组合 1"/>
            <p:cNvGrpSpPr/>
            <p:nvPr/>
          </p:nvGrpSpPr>
          <p:grpSpPr>
            <a:xfrm>
              <a:off x="714348" y="3071810"/>
              <a:ext cx="4024319" cy="3074445"/>
              <a:chOff x="2071670" y="2845354"/>
              <a:chExt cx="4024319" cy="3074445"/>
            </a:xfrm>
          </p:grpSpPr>
          <p:pic>
            <p:nvPicPr>
              <p:cNvPr id="10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3000364" y="2900363"/>
                <a:ext cx="3067050" cy="10572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1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3000364" y="4000504"/>
                <a:ext cx="3086100" cy="9715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2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3000364" y="5072074"/>
                <a:ext cx="3095625" cy="8477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4" name="组合 7"/>
              <p:cNvGrpSpPr/>
              <p:nvPr/>
            </p:nvGrpSpPr>
            <p:grpSpPr>
              <a:xfrm>
                <a:off x="2071670" y="2845354"/>
                <a:ext cx="1428760" cy="2953242"/>
                <a:chOff x="2214546" y="845090"/>
                <a:chExt cx="1428760" cy="2953242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>
                  <a:off x="2214546" y="845090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2214546" y="987966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2214546" y="1357298"/>
                  <a:ext cx="142876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285984" y="1714488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19" name="TextBox 12"/>
                <p:cNvSpPr txBox="1"/>
                <p:nvPr/>
              </p:nvSpPr>
              <p:spPr>
                <a:xfrm>
                  <a:off x="2285984" y="2285992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285984" y="2702478"/>
                  <a:ext cx="8572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285984" y="3429000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</p:grpSp>
        </p:grpSp>
        <p:sp>
          <p:nvSpPr>
            <p:cNvPr id="6" name="TextBox 5"/>
            <p:cNvSpPr txBox="1"/>
            <p:nvPr/>
          </p:nvSpPr>
          <p:spPr>
            <a:xfrm rot="18900000">
              <a:off x="1946637" y="2682376"/>
              <a:ext cx="4721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SB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2605900" y="2494285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 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2193975" y="2494284"/>
              <a:ext cx="10510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SB+Cd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 rot="18900000">
              <a:off x="3004517" y="2553587"/>
              <a:ext cx="7627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Cd</a:t>
              </a:r>
              <a:endParaRPr lang="zh-CN" altLang="en-US" dirty="0"/>
            </a:p>
          </p:txBody>
        </p:sp>
      </p:grp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5649886" y="2195629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648189" y="2418727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909666" y="2214845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C22DC2B-4B13-42E3-A980-3C1F1F4D3999}"/>
              </a:ext>
            </a:extLst>
          </p:cNvPr>
          <p:cNvSpPr txBox="1"/>
          <p:nvPr/>
        </p:nvSpPr>
        <p:spPr>
          <a:xfrm>
            <a:off x="5930609" y="1956215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666387" y="424553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930609" y="40608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0" y="928670"/>
            <a:ext cx="8806424" cy="4884205"/>
            <a:chOff x="0" y="928670"/>
            <a:chExt cx="8806424" cy="4884205"/>
          </a:xfrm>
        </p:grpSpPr>
        <p:grpSp>
          <p:nvGrpSpPr>
            <p:cNvPr id="4" name="组合 1"/>
            <p:cNvGrpSpPr/>
            <p:nvPr/>
          </p:nvGrpSpPr>
          <p:grpSpPr>
            <a:xfrm>
              <a:off x="0" y="2285992"/>
              <a:ext cx="8806424" cy="3526883"/>
              <a:chOff x="214282" y="3331117"/>
              <a:chExt cx="8806424" cy="3526883"/>
            </a:xfrm>
          </p:grpSpPr>
          <p:grpSp>
            <p:nvGrpSpPr>
              <p:cNvPr id="10" name="组合 43"/>
              <p:cNvGrpSpPr/>
              <p:nvPr/>
            </p:nvGrpSpPr>
            <p:grpSpPr>
              <a:xfrm>
                <a:off x="214282" y="3331117"/>
                <a:ext cx="5576894" cy="3526883"/>
                <a:chOff x="1214414" y="3273982"/>
                <a:chExt cx="5576894" cy="3526883"/>
              </a:xfrm>
            </p:grpSpPr>
            <p:pic>
              <p:nvPicPr>
                <p:cNvPr id="13" name="Picture 2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 bwMode="auto">
                <a:xfrm>
                  <a:off x="2143107" y="3286124"/>
                  <a:ext cx="4647600" cy="7474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4" name="Picture 3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2143108" y="4429132"/>
                  <a:ext cx="4647600" cy="51104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5" name="Picture 4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2143108" y="5572140"/>
                  <a:ext cx="4648200" cy="12287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6" name="Picture 5"/>
                <p:cNvPicPr>
                  <a:picLocks noChangeAspect="1" noChangeArrowheads="1"/>
                </p:cNvPicPr>
                <p:nvPr/>
              </p:nvPicPr>
              <p:blipFill>
                <a:blip r:embed="rId5"/>
                <a:srcRect/>
                <a:stretch>
                  <a:fillRect/>
                </a:stretch>
              </p:blipFill>
              <p:spPr bwMode="auto">
                <a:xfrm>
                  <a:off x="2138978" y="4929198"/>
                  <a:ext cx="4647600" cy="6328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7" name="Picture 6"/>
                <p:cNvPicPr>
                  <a:picLocks noChangeAspect="1" noChangeArrowheads="1"/>
                </p:cNvPicPr>
                <p:nvPr/>
              </p:nvPicPr>
              <p:blipFill>
                <a:blip r:embed="rId6"/>
                <a:srcRect/>
                <a:stretch>
                  <a:fillRect/>
                </a:stretch>
              </p:blipFill>
              <p:spPr bwMode="auto">
                <a:xfrm>
                  <a:off x="2143107" y="4014794"/>
                  <a:ext cx="4647600" cy="4867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1214414" y="3273982"/>
                  <a:ext cx="128588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214414" y="3429000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214414" y="392906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285852" y="4214818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357290" y="4786322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357290" y="535782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1357290" y="6000768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1357290" y="642939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</p:grpSp>
          <p:pic>
            <p:nvPicPr>
              <p:cNvPr id="11" name="Picture 2"/>
              <p:cNvPicPr>
                <a:picLocks noChangeAspect="1"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6010418" y="5958176"/>
                <a:ext cx="3010288" cy="8976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6010418" y="5277328"/>
                <a:ext cx="26431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Stripping and Reprobing</a:t>
                </a:r>
                <a:endParaRPr lang="zh-CN" altLang="en-US" dirty="0"/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857224" y="928670"/>
              <a:ext cx="20717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3A 2020.6.23  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 rot="18900000">
              <a:off x="3395536" y="1784088"/>
              <a:ext cx="7858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3708032" y="1623808"/>
              <a:ext cx="12106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d20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4137892" y="1671042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Azo</a:t>
              </a:r>
              <a:r>
                <a:rPr lang="en-US" altLang="zh-CN" dirty="0"/>
                <a:t> 20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 rot="18900000">
              <a:off x="4499222" y="1521438"/>
              <a:ext cx="1500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zo20+Cd20</a:t>
              </a:r>
              <a:endParaRPr lang="zh-CN" altLang="en-US" dirty="0"/>
            </a:p>
          </p:txBody>
        </p:sp>
      </p:grpSp>
      <p:sp>
        <p:nvSpPr>
          <p:cNvPr id="26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6298675" y="4241495"/>
            <a:ext cx="360040" cy="1209203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4A2064F0-A43C-454D-B17D-67A0295F1A0E}"/>
              </a:ext>
            </a:extLst>
          </p:cNvPr>
          <p:cNvCxnSpPr/>
          <p:nvPr/>
        </p:nvCxnSpPr>
        <p:spPr>
          <a:xfrm flipH="1">
            <a:off x="5648823" y="332143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0">
            <a:extLst>
              <a:ext uri="{FF2B5EF4-FFF2-40B4-BE49-F238E27FC236}">
                <a16:creationId xmlns:a16="http://schemas.microsoft.com/office/drawing/2014/main" id="{2EB1B906-2962-4059-9972-2515E3A9C2C9}"/>
              </a:ext>
            </a:extLst>
          </p:cNvPr>
          <p:cNvSpPr txBox="1"/>
          <p:nvPr/>
        </p:nvSpPr>
        <p:spPr>
          <a:xfrm>
            <a:off x="5910300" y="3192336"/>
            <a:ext cx="484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C95619F4-21CC-437A-89F8-909131154FB3}"/>
              </a:ext>
            </a:extLst>
          </p:cNvPr>
          <p:cNvCxnSpPr/>
          <p:nvPr/>
        </p:nvCxnSpPr>
        <p:spPr>
          <a:xfrm flipH="1">
            <a:off x="5648823" y="485042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2">
            <a:extLst>
              <a:ext uri="{FF2B5EF4-FFF2-40B4-BE49-F238E27FC236}">
                <a16:creationId xmlns:a16="http://schemas.microsoft.com/office/drawing/2014/main" id="{DFB827B7-A021-4488-B4E4-E7EFD5AA587E}"/>
              </a:ext>
            </a:extLst>
          </p:cNvPr>
          <p:cNvSpPr txBox="1"/>
          <p:nvPr/>
        </p:nvSpPr>
        <p:spPr>
          <a:xfrm>
            <a:off x="5910300" y="472132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7"/>
          <p:cNvGrpSpPr/>
          <p:nvPr/>
        </p:nvGrpSpPr>
        <p:grpSpPr>
          <a:xfrm>
            <a:off x="428596" y="2071702"/>
            <a:ext cx="1428760" cy="2226696"/>
            <a:chOff x="2214546" y="845090"/>
            <a:chExt cx="1428760" cy="2226696"/>
          </a:xfrm>
        </p:grpSpPr>
        <p:sp>
          <p:nvSpPr>
            <p:cNvPr id="14" name="TextBox 13"/>
            <p:cNvSpPr txBox="1"/>
            <p:nvPr/>
          </p:nvSpPr>
          <p:spPr>
            <a:xfrm>
              <a:off x="2214546" y="845090"/>
              <a:ext cx="1143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70KDa-</a:t>
              </a:r>
              <a:endParaRPr lang="zh-CN" alt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214546" y="987966"/>
              <a:ext cx="10001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30KDa-</a:t>
              </a:r>
              <a:endParaRPr lang="zh-CN" alt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14546" y="1202256"/>
              <a:ext cx="1428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0KDa-</a:t>
              </a:r>
              <a:endParaRPr lang="zh-CN" alt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285984" y="1559446"/>
              <a:ext cx="12144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70KDa-</a:t>
              </a:r>
              <a:endParaRPr lang="zh-CN" altLang="en-US" dirty="0"/>
            </a:p>
          </p:txBody>
        </p:sp>
        <p:sp>
          <p:nvSpPr>
            <p:cNvPr id="18" name="TextBox 12"/>
            <p:cNvSpPr txBox="1"/>
            <p:nvPr/>
          </p:nvSpPr>
          <p:spPr>
            <a:xfrm>
              <a:off x="2285984" y="1845198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55KDa-</a:t>
              </a:r>
              <a:endParaRPr lang="zh-CN" alt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285984" y="2273826"/>
              <a:ext cx="8572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40KDa-</a:t>
              </a:r>
              <a:endParaRPr lang="zh-CN" altLang="en-US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85984" y="2702454"/>
              <a:ext cx="10001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5KDa-</a:t>
              </a:r>
              <a:endParaRPr lang="zh-CN" altLang="en-US" dirty="0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857224" y="571480"/>
            <a:ext cx="2214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E 2023.10.3 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 rot="18900000">
            <a:off x="3276115" y="1589513"/>
            <a:ext cx="472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B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18900000">
            <a:off x="2351996" y="148867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 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18900000">
            <a:off x="3548527" y="1384836"/>
            <a:ext cx="1051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B+Cd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18900000">
            <a:off x="2804920" y="1501462"/>
            <a:ext cx="762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Cd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5002325" y="239751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000628" y="262060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262105" y="2416726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24" name="文本框 24">
            <a:extLst>
              <a:ext uri="{FF2B5EF4-FFF2-40B4-BE49-F238E27FC236}">
                <a16:creationId xmlns:a16="http://schemas.microsoft.com/office/drawing/2014/main" id="{0C22DC2B-4B13-42E3-A980-3C1F1F4D3999}"/>
              </a:ext>
            </a:extLst>
          </p:cNvPr>
          <p:cNvSpPr txBox="1"/>
          <p:nvPr/>
        </p:nvSpPr>
        <p:spPr>
          <a:xfrm>
            <a:off x="5283048" y="2158096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000628" y="400050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214942" y="378619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357290" y="2000240"/>
            <a:ext cx="3581400" cy="403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矩形 28"/>
          <p:cNvSpPr/>
          <p:nvPr/>
        </p:nvSpPr>
        <p:spPr>
          <a:xfrm>
            <a:off x="500034" y="4282867"/>
            <a:ext cx="8627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30" name="矩形 29"/>
          <p:cNvSpPr/>
          <p:nvPr/>
        </p:nvSpPr>
        <p:spPr>
          <a:xfrm>
            <a:off x="500034" y="492919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000100" y="714356"/>
            <a:ext cx="1997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E  2023.10. 14 </a:t>
            </a:r>
            <a:endParaRPr lang="zh-CN" alt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57356" y="2000240"/>
            <a:ext cx="3171825" cy="3067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857884" y="4714884"/>
            <a:ext cx="3152775" cy="1095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 rot="18900000">
            <a:off x="3061802" y="1589513"/>
            <a:ext cx="472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B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-2700000">
            <a:off x="2219971" y="1488677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 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 rot="18900000">
            <a:off x="3334214" y="1384836"/>
            <a:ext cx="1051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B+Cd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 rot="-2700000">
            <a:off x="2590607" y="1501462"/>
            <a:ext cx="762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Cd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28662" y="213097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00100" y="250030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000100" y="278605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000100" y="3071810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000100" y="414338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989138" y="357187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994619" y="335756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928662" y="198809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928662" y="228599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5002325" y="228599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000628" y="24288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262105" y="2273850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21" name="文本框 24">
            <a:extLst>
              <a:ext uri="{FF2B5EF4-FFF2-40B4-BE49-F238E27FC236}">
                <a16:creationId xmlns:a16="http://schemas.microsoft.com/office/drawing/2014/main" id="{0C22DC2B-4B13-42E3-A980-3C1F1F4D3999}"/>
              </a:ext>
            </a:extLst>
          </p:cNvPr>
          <p:cNvSpPr txBox="1"/>
          <p:nvPr/>
        </p:nvSpPr>
        <p:spPr>
          <a:xfrm>
            <a:off x="5283048" y="2059536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sp>
        <p:nvSpPr>
          <p:cNvPr id="23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4774421" y="505993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4E3BF80-8DBB-4CC2-BAE4-5C1E60588A4D}"/>
              </a:ext>
            </a:extLst>
          </p:cNvPr>
          <p:cNvSpPr txBox="1"/>
          <p:nvPr/>
        </p:nvSpPr>
        <p:spPr>
          <a:xfrm>
            <a:off x="5643570" y="4214818"/>
            <a:ext cx="372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7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5893603" y="2536025"/>
            <a:ext cx="571504" cy="2357454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>
            <a:off x="5500694" y="5214950"/>
            <a:ext cx="330970" cy="15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142976" y="857232"/>
            <a:ext cx="18325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F 2020.12.25</a:t>
            </a:r>
            <a:endParaRPr lang="zh-CN" altLang="en-US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357290" y="1928802"/>
            <a:ext cx="5648325" cy="1162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357290" y="3000372"/>
            <a:ext cx="5648400" cy="8876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68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357290" y="4000504"/>
            <a:ext cx="5648400" cy="944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4"/>
          <p:cNvSpPr txBox="1"/>
          <p:nvPr/>
        </p:nvSpPr>
        <p:spPr>
          <a:xfrm rot="-2700000">
            <a:off x="5009134" y="143580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5333864" y="128560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Cd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5709529" y="138528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p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6068937" y="118323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p+Cd</a:t>
            </a:r>
            <a:endParaRPr lang="zh-CN" altLang="en-US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7220235" y="24539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7218538" y="267706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7480015" y="2473184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22" name="文本框 24">
            <a:extLst>
              <a:ext uri="{FF2B5EF4-FFF2-40B4-BE49-F238E27FC236}">
                <a16:creationId xmlns:a16="http://schemas.microsoft.com/office/drawing/2014/main" id="{0C22DC2B-4B13-42E3-A980-3C1F1F4D3999}"/>
              </a:ext>
            </a:extLst>
          </p:cNvPr>
          <p:cNvSpPr txBox="1"/>
          <p:nvPr/>
        </p:nvSpPr>
        <p:spPr>
          <a:xfrm>
            <a:off x="7500958" y="2214554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7143768" y="425660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407990" y="407194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2482762" y="140683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 rot="-2700000">
            <a:off x="2793812" y="123117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Cd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 rot="-2700000">
            <a:off x="3191475" y="133525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p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 rot="-2700000">
            <a:off x="3503508" y="1133195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p+Cd</a:t>
            </a:r>
            <a:endParaRPr lang="zh-CN" altLang="en-US" dirty="0"/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85786" y="714356"/>
            <a:ext cx="17684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5F 2023.9.7 2</a:t>
            </a:r>
            <a:endParaRPr lang="zh-CN" altLang="en-US" dirty="0"/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14414" y="1785926"/>
            <a:ext cx="5981700" cy="3638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7220235" y="207167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7480015" y="2071678"/>
            <a:ext cx="973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PARP1</a:t>
            </a:r>
            <a:endParaRPr lang="zh-CN" altLang="en-US" dirty="0"/>
          </a:p>
        </p:txBody>
      </p:sp>
      <p:sp>
        <p:nvSpPr>
          <p:cNvPr id="6" name="文本框 24">
            <a:extLst>
              <a:ext uri="{FF2B5EF4-FFF2-40B4-BE49-F238E27FC236}">
                <a16:creationId xmlns:a16="http://schemas.microsoft.com/office/drawing/2014/main" id="{0C22DC2B-4B13-42E3-A980-3C1F1F4D3999}"/>
              </a:ext>
            </a:extLst>
          </p:cNvPr>
          <p:cNvSpPr txBox="1"/>
          <p:nvPr/>
        </p:nvSpPr>
        <p:spPr>
          <a:xfrm>
            <a:off x="7500958" y="1857364"/>
            <a:ext cx="780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RP1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7215206" y="354222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479428" y="335756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C05B9C98-06DC-4933-80F4-D928B32989BD}"/>
              </a:ext>
            </a:extLst>
          </p:cNvPr>
          <p:cNvCxnSpPr/>
          <p:nvPr/>
        </p:nvCxnSpPr>
        <p:spPr>
          <a:xfrm flipH="1">
            <a:off x="7215206" y="228599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85720" y="242886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85720" y="270247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85720" y="313110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274758" y="377404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280239" y="3488296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214282" y="170234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214282" y="185736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4726845" y="1180768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5078081" y="1002664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Cd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5518442" y="111816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p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5813571" y="907055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p+Cd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214282" y="214311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351677" y="448842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57290" y="178592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357290" y="2000240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28728" y="227385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428728" y="255960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428728" y="2988230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28728" y="434555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1417766" y="363117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1423247" y="3357562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1357290" y="1643050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2611267" y="928539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2960496" y="757290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302191" y="81608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3558618" y="658681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6578" y="1428736"/>
            <a:ext cx="4500000" cy="39441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" name="矩形 15"/>
          <p:cNvSpPr/>
          <p:nvPr/>
        </p:nvSpPr>
        <p:spPr>
          <a:xfrm>
            <a:off x="1142976" y="357166"/>
            <a:ext cx="24646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B  BECN1 2023.10.3</a:t>
            </a:r>
            <a:endParaRPr lang="zh-CN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357422" y="5708688"/>
            <a:ext cx="4500000" cy="1149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6786578" y="247773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7048055" y="2273850"/>
            <a:ext cx="80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ECN1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6858016" y="62865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122238" y="60600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357554" y="3643314"/>
            <a:ext cx="214314" cy="2428892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571868" y="534568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3108" y="6029325"/>
            <a:ext cx="4381500" cy="828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1052184" y="157161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52184" y="172663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052184" y="194096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123622" y="222672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195060" y="257176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195060" y="292893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195060" y="335756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195060" y="364331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195060" y="4357694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2425235" y="102270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784932" y="88777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3190909" y="95416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3517083" y="770128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4010712" y="1044087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4363003" y="872497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4808587" y="98029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5107375" y="744004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071670" y="1571612"/>
            <a:ext cx="4391025" cy="3905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6500826" y="254917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6762303" y="2345288"/>
            <a:ext cx="80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ECN1</a:t>
            </a:r>
            <a:endParaRPr lang="zh-CN" altLang="en-US" dirty="0"/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6572264" y="62865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6836486" y="60600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6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2123754" y="3744848"/>
            <a:ext cx="214314" cy="2428892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3286116" y="5559998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500034" y="214290"/>
            <a:ext cx="25816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B BECN1  2023.10.12</a:t>
            </a:r>
            <a:endParaRPr lang="zh-CN" altLang="en-US" dirty="0"/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85852" y="1643050"/>
            <a:ext cx="4371975" cy="3524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214282" y="0"/>
            <a:ext cx="3500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6C LC3BII 2023.9.7  1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57158" y="157161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57158" y="172663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57158" y="192880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28596" y="220241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0034" y="251244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00034" y="285749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00034" y="321468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0034" y="348829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0034" y="421481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1703181" y="111791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049372" y="92389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2455756" y="98210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2759096" y="82152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85852" y="5643578"/>
            <a:ext cx="4352925" cy="83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667845" y="449013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929322" y="4286256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715008" y="601291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979230" y="578645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1357290" y="3429060"/>
            <a:ext cx="142876" cy="22860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786182" y="5214950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64305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0" y="179806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0" y="192880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1438" y="2130974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42876" y="22859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2876" y="257174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42876" y="285749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42876" y="307181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42876" y="357187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1158507" y="1161871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1435501" y="96858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1747604" y="110334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1974146" y="867530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310655" y="38471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5572132" y="3643314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307910" y="53699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572132" y="514351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2285984" y="435769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28662" y="1714488"/>
            <a:ext cx="4320000" cy="25851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3" name="矩形 22"/>
          <p:cNvSpPr/>
          <p:nvPr/>
        </p:nvSpPr>
        <p:spPr>
          <a:xfrm>
            <a:off x="142844" y="0"/>
            <a:ext cx="24680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C LC3BII 2023.9.7  2</a:t>
            </a:r>
            <a:endParaRPr lang="zh-CN" altLang="en-US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966380" y="4705413"/>
            <a:ext cx="4320000" cy="1009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0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990687" y="2946152"/>
            <a:ext cx="142876" cy="200026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142852"/>
            <a:ext cx="2637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C LC3BII 2023.9.27   1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42844" y="164305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2844" y="179806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42844" y="2000240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85720" y="235743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5720" y="258388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5720" y="292893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85720" y="328612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5720" y="365545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85720" y="4357694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1551912" y="116788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1898105" y="96796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308027" y="110201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2660581" y="872114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-2700000">
            <a:off x="3828309" y="97773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-2700000">
            <a:off x="4225328" y="102753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 rot="-2700000">
            <a:off x="4581083" y="83041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6000760" y="462087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6262237" y="4416990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6000760" y="342900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6264982" y="320254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8" y="3929066"/>
            <a:ext cx="4842000" cy="14716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71538" y="2500306"/>
            <a:ext cx="4852800" cy="13826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071538" y="1714488"/>
            <a:ext cx="4819650" cy="800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8" name="矩形 27"/>
          <p:cNvSpPr/>
          <p:nvPr/>
        </p:nvSpPr>
        <p:spPr>
          <a:xfrm rot="-2700000">
            <a:off x="3506987" y="1241230"/>
            <a:ext cx="6094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14282" y="428604"/>
            <a:ext cx="6634177" cy="5291165"/>
            <a:chOff x="928662" y="-1071594"/>
            <a:chExt cx="6634177" cy="5291165"/>
          </a:xfrm>
        </p:grpSpPr>
        <p:grpSp>
          <p:nvGrpSpPr>
            <p:cNvPr id="3" name="组合 10"/>
            <p:cNvGrpSpPr/>
            <p:nvPr/>
          </p:nvGrpSpPr>
          <p:grpSpPr>
            <a:xfrm>
              <a:off x="2071670" y="214290"/>
              <a:ext cx="1428760" cy="3429024"/>
              <a:chOff x="2143108" y="928670"/>
              <a:chExt cx="1428760" cy="3429024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2143108" y="928670"/>
                <a:ext cx="11430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170KDa-</a:t>
                </a:r>
                <a:endParaRPr lang="zh-CN" altLang="en-US" dirty="0"/>
              </a:p>
            </p:txBody>
          </p:sp>
          <p:sp>
            <p:nvSpPr>
              <p:cNvPr id="10" name="TextBox 2"/>
              <p:cNvSpPr txBox="1"/>
              <p:nvPr/>
            </p:nvSpPr>
            <p:spPr>
              <a:xfrm>
                <a:off x="2143108" y="1071546"/>
                <a:ext cx="1000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130KDa-</a:t>
                </a:r>
                <a:endParaRPr lang="zh-CN" altLang="en-US" dirty="0"/>
              </a:p>
            </p:txBody>
          </p:sp>
          <p:sp>
            <p:nvSpPr>
              <p:cNvPr id="11" name="TextBox 3"/>
              <p:cNvSpPr txBox="1"/>
              <p:nvPr/>
            </p:nvSpPr>
            <p:spPr>
              <a:xfrm>
                <a:off x="2143108" y="1357298"/>
                <a:ext cx="14287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100KDa-</a:t>
                </a:r>
                <a:endParaRPr lang="zh-CN" altLang="en-US" dirty="0"/>
              </a:p>
            </p:txBody>
          </p:sp>
          <p:sp>
            <p:nvSpPr>
              <p:cNvPr id="12" name="TextBox 4"/>
              <p:cNvSpPr txBox="1"/>
              <p:nvPr/>
            </p:nvSpPr>
            <p:spPr>
              <a:xfrm>
                <a:off x="2285984" y="1714488"/>
                <a:ext cx="12144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70KDa-</a:t>
                </a:r>
                <a:endParaRPr lang="zh-CN" altLang="en-US" dirty="0"/>
              </a:p>
            </p:txBody>
          </p:sp>
          <p:sp>
            <p:nvSpPr>
              <p:cNvPr id="13" name="TextBox 5"/>
              <p:cNvSpPr txBox="1"/>
              <p:nvPr/>
            </p:nvSpPr>
            <p:spPr>
              <a:xfrm>
                <a:off x="2285984" y="2071678"/>
                <a:ext cx="9286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55KDa-</a:t>
                </a:r>
                <a:endParaRPr lang="zh-CN" altLang="en-US" dirty="0"/>
              </a:p>
            </p:txBody>
          </p:sp>
          <p:sp>
            <p:nvSpPr>
              <p:cNvPr id="14" name="TextBox 6"/>
              <p:cNvSpPr txBox="1"/>
              <p:nvPr/>
            </p:nvSpPr>
            <p:spPr>
              <a:xfrm>
                <a:off x="2285984" y="2571744"/>
                <a:ext cx="8572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40KDa-</a:t>
                </a:r>
                <a:endParaRPr lang="zh-CN" altLang="en-US" dirty="0"/>
              </a:p>
            </p:txBody>
          </p:sp>
          <p:sp>
            <p:nvSpPr>
              <p:cNvPr id="15" name="TextBox 7"/>
              <p:cNvSpPr txBox="1"/>
              <p:nvPr/>
            </p:nvSpPr>
            <p:spPr>
              <a:xfrm>
                <a:off x="2285984" y="3000372"/>
                <a:ext cx="1000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35KDa-</a:t>
                </a:r>
                <a:endParaRPr lang="zh-CN" altLang="en-US" dirty="0"/>
              </a:p>
            </p:txBody>
          </p:sp>
          <p:sp>
            <p:nvSpPr>
              <p:cNvPr id="16" name="TextBox 8"/>
              <p:cNvSpPr txBox="1"/>
              <p:nvPr/>
            </p:nvSpPr>
            <p:spPr>
              <a:xfrm>
                <a:off x="2285984" y="3429000"/>
                <a:ext cx="1000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25KDa-</a:t>
                </a:r>
                <a:endParaRPr lang="zh-CN" altLang="en-US" dirty="0"/>
              </a:p>
            </p:txBody>
          </p:sp>
          <p:sp>
            <p:nvSpPr>
              <p:cNvPr id="17" name="TextBox 9"/>
              <p:cNvSpPr txBox="1"/>
              <p:nvPr/>
            </p:nvSpPr>
            <p:spPr>
              <a:xfrm>
                <a:off x="2285984" y="3988362"/>
                <a:ext cx="11430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15KDa-</a:t>
                </a:r>
                <a:endParaRPr lang="zh-CN" altLang="en-US" dirty="0"/>
              </a:p>
            </p:txBody>
          </p:sp>
        </p:grpSp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000364" y="214290"/>
              <a:ext cx="4561200" cy="9830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00364" y="1214422"/>
              <a:ext cx="4561200" cy="7142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4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3000364" y="1928802"/>
              <a:ext cx="4561200" cy="9443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5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3000364" y="2857496"/>
              <a:ext cx="4562475" cy="13620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TextBox 7"/>
            <p:cNvSpPr txBox="1"/>
            <p:nvPr/>
          </p:nvSpPr>
          <p:spPr>
            <a:xfrm>
              <a:off x="928662" y="-1071594"/>
              <a:ext cx="33575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6E BECN1 LC3BII 2020.1.2</a:t>
              </a:r>
              <a:endParaRPr lang="zh-CN" alt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 rot="-2700000">
            <a:off x="2658673" y="126429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 rot="-2700000">
            <a:off x="3120606" y="1264291"/>
            <a:ext cx="714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 rot="-2700000">
            <a:off x="3752829" y="99683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 rot="-2700000">
            <a:off x="3460565" y="1200545"/>
            <a:ext cx="8127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10026B86-4854-4BBC-93AF-FE97812A0FB9}"/>
              </a:ext>
            </a:extLst>
          </p:cNvPr>
          <p:cNvCxnSpPr/>
          <p:nvPr/>
        </p:nvCxnSpPr>
        <p:spPr>
          <a:xfrm flipH="1">
            <a:off x="7000892" y="389012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D69762B4-02F1-4F2F-9FC2-4190796666F9}"/>
              </a:ext>
            </a:extLst>
          </p:cNvPr>
          <p:cNvCxnSpPr/>
          <p:nvPr/>
        </p:nvCxnSpPr>
        <p:spPr>
          <a:xfrm flipH="1">
            <a:off x="7000892" y="2928934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CEC5D3E3-BFE2-4109-A298-875D638076A4}"/>
              </a:ext>
            </a:extLst>
          </p:cNvPr>
          <p:cNvCxnSpPr/>
          <p:nvPr/>
        </p:nvCxnSpPr>
        <p:spPr>
          <a:xfrm flipH="1">
            <a:off x="7000892" y="485776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2">
            <a:extLst>
              <a:ext uri="{FF2B5EF4-FFF2-40B4-BE49-F238E27FC236}">
                <a16:creationId xmlns:a16="http://schemas.microsoft.com/office/drawing/2014/main" id="{19430B51-1135-4548-8482-37279C6576FE}"/>
              </a:ext>
            </a:extLst>
          </p:cNvPr>
          <p:cNvSpPr txBox="1"/>
          <p:nvPr/>
        </p:nvSpPr>
        <p:spPr>
          <a:xfrm>
            <a:off x="7215206" y="373331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6" name="文本框 26">
            <a:extLst>
              <a:ext uri="{FF2B5EF4-FFF2-40B4-BE49-F238E27FC236}">
                <a16:creationId xmlns:a16="http://schemas.microsoft.com/office/drawing/2014/main" id="{61CEFC61-A3E5-4340-938B-51BFFB97B948}"/>
              </a:ext>
            </a:extLst>
          </p:cNvPr>
          <p:cNvSpPr txBox="1"/>
          <p:nvPr/>
        </p:nvSpPr>
        <p:spPr>
          <a:xfrm>
            <a:off x="7286644" y="2714620"/>
            <a:ext cx="80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ECN1</a:t>
            </a:r>
            <a:endParaRPr lang="zh-CN" altLang="en-US" dirty="0"/>
          </a:p>
        </p:txBody>
      </p:sp>
      <p:sp>
        <p:nvSpPr>
          <p:cNvPr id="27" name="文本框 28">
            <a:extLst>
              <a:ext uri="{FF2B5EF4-FFF2-40B4-BE49-F238E27FC236}">
                <a16:creationId xmlns:a16="http://schemas.microsoft.com/office/drawing/2014/main" id="{7D947EE9-686A-4C09-85AF-AA7474E56259}"/>
              </a:ext>
            </a:extLst>
          </p:cNvPr>
          <p:cNvSpPr txBox="1"/>
          <p:nvPr/>
        </p:nvSpPr>
        <p:spPr>
          <a:xfrm>
            <a:off x="7215206" y="4643446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5918" y="1857364"/>
            <a:ext cx="2247900" cy="1304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428596" y="571480"/>
            <a:ext cx="20185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A 2023.9.21 2  </a:t>
            </a:r>
            <a:endParaRPr lang="zh-CN" altLang="en-US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4A2064F0-A43C-454D-B17D-67A0295F1A0E}"/>
              </a:ext>
            </a:extLst>
          </p:cNvPr>
          <p:cNvCxnSpPr/>
          <p:nvPr/>
        </p:nvCxnSpPr>
        <p:spPr>
          <a:xfrm flipH="1">
            <a:off x="4167647" y="205790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30">
            <a:extLst>
              <a:ext uri="{FF2B5EF4-FFF2-40B4-BE49-F238E27FC236}">
                <a16:creationId xmlns:a16="http://schemas.microsoft.com/office/drawing/2014/main" id="{2EB1B906-2962-4059-9972-2515E3A9C2C9}"/>
              </a:ext>
            </a:extLst>
          </p:cNvPr>
          <p:cNvSpPr txBox="1"/>
          <p:nvPr/>
        </p:nvSpPr>
        <p:spPr>
          <a:xfrm>
            <a:off x="4357686" y="1857364"/>
            <a:ext cx="484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C95619F4-21CC-437A-89F8-909131154FB3}"/>
              </a:ext>
            </a:extLst>
          </p:cNvPr>
          <p:cNvCxnSpPr/>
          <p:nvPr/>
        </p:nvCxnSpPr>
        <p:spPr>
          <a:xfrm flipH="1">
            <a:off x="4155754" y="277228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32">
            <a:extLst>
              <a:ext uri="{FF2B5EF4-FFF2-40B4-BE49-F238E27FC236}">
                <a16:creationId xmlns:a16="http://schemas.microsoft.com/office/drawing/2014/main" id="{DFB827B7-A021-4488-B4E4-E7EFD5AA587E}"/>
              </a:ext>
            </a:extLst>
          </p:cNvPr>
          <p:cNvSpPr txBox="1"/>
          <p:nvPr/>
        </p:nvSpPr>
        <p:spPr>
          <a:xfrm>
            <a:off x="4417231" y="257174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57224" y="185736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28662" y="200024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00100" y="235743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000100" y="255960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000100" y="2786058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18900000">
            <a:off x="1944292" y="1335728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18900000">
            <a:off x="2256788" y="1175448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 rot="18900000">
            <a:off x="2686648" y="128521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 rot="18900000">
            <a:off x="3047978" y="1073078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214290"/>
            <a:ext cx="25688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E BECN1 2023.9.29 2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0" y="241672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0" y="257174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278605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1438" y="300037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2876" y="328612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42876" y="364331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42876" y="407194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42876" y="435769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42876" y="505993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1378207" y="1949982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1724398" y="1785899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2141028" y="183388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-2700000">
            <a:off x="2379089" y="1695468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3453267" y="34185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3714744" y="3214686"/>
            <a:ext cx="80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ECN1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6879546" y="429839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143768" y="407194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4357686" y="364331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28662" y="2466989"/>
            <a:ext cx="2428875" cy="2962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429124" y="4000504"/>
            <a:ext cx="2447925" cy="1466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0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 rot="16200000">
            <a:off x="3804042" y="3982644"/>
            <a:ext cx="250033" cy="128588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2876" y="1500174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42876" y="165519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2876" y="178592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14314" y="200024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85752" y="221455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5752" y="250030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5752" y="278605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85752" y="300037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5752" y="350043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2627846" y="1028133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2842832" y="89021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 rot="-2700000">
            <a:off x="3167646" y="95627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 rot="-2700000">
            <a:off x="3398642" y="80350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786446" y="234699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6047923" y="2143116"/>
            <a:ext cx="80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ECN1</a:t>
            </a:r>
            <a:endParaRPr lang="zh-CN" altLang="en-US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807976" y="572715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6072198" y="550070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2428860" y="471488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8" y="1571612"/>
            <a:ext cx="4680000" cy="2810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71538" y="5286388"/>
            <a:ext cx="4680000" cy="7934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2357422" y="2776771"/>
            <a:ext cx="142876" cy="271464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214282" y="214290"/>
            <a:ext cx="25159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E BECN1 2023.10.17</a:t>
            </a:r>
            <a:endParaRPr lang="zh-CN" altLang="en-US" dirty="0"/>
          </a:p>
        </p:txBody>
      </p:sp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A7ECBBA-A86F-7375-F302-540B08DD55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32" y="128296"/>
            <a:ext cx="7009678" cy="5222897"/>
          </a:xfrm>
          <a:prstGeom prst="rect">
            <a:avLst/>
          </a:prstGeom>
        </p:spPr>
      </p:pic>
      <p:sp>
        <p:nvSpPr>
          <p:cNvPr id="27" name="矩形 26"/>
          <p:cNvSpPr/>
          <p:nvPr/>
        </p:nvSpPr>
        <p:spPr>
          <a:xfrm>
            <a:off x="293816" y="88567"/>
            <a:ext cx="19935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F LC3BII 20.1.2</a:t>
            </a:r>
            <a:endParaRPr lang="zh-CN" alt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857224" y="270247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857224" y="305966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857224" y="334542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857224" y="413123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38" name="TextBox 37"/>
          <p:cNvSpPr txBox="1"/>
          <p:nvPr/>
        </p:nvSpPr>
        <p:spPr>
          <a:xfrm rot="-2700000">
            <a:off x="1796644" y="2048602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39" name="TextBox 38"/>
          <p:cNvSpPr txBox="1"/>
          <p:nvPr/>
        </p:nvSpPr>
        <p:spPr>
          <a:xfrm rot="-2700000">
            <a:off x="2065690" y="1916946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40" name="TextBox 39"/>
          <p:cNvSpPr txBox="1"/>
          <p:nvPr/>
        </p:nvSpPr>
        <p:spPr>
          <a:xfrm rot="-2700000">
            <a:off x="2500847" y="198709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41" name="TextBox 40"/>
          <p:cNvSpPr txBox="1"/>
          <p:nvPr/>
        </p:nvSpPr>
        <p:spPr>
          <a:xfrm rot="-2700000">
            <a:off x="2838251" y="1766381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6175259" y="43351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6436736" y="4131238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6009084" y="288667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6273306" y="266022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85AAB6D-AF0F-846D-43B4-7164C5F99B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4928" y="3745345"/>
            <a:ext cx="4389537" cy="13636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597958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643042" y="1357298"/>
            <a:ext cx="5619750" cy="3343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矩形 26"/>
          <p:cNvSpPr/>
          <p:nvPr/>
        </p:nvSpPr>
        <p:spPr>
          <a:xfrm>
            <a:off x="293816" y="88567"/>
            <a:ext cx="23446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F LC3BII 2023.9.18</a:t>
            </a:r>
            <a:endParaRPr lang="zh-CN" altLang="en-US" dirty="0"/>
          </a:p>
        </p:txBody>
      </p:sp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643042" y="5114944"/>
            <a:ext cx="5600700" cy="1028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TextBox 28"/>
          <p:cNvSpPr txBox="1"/>
          <p:nvPr/>
        </p:nvSpPr>
        <p:spPr>
          <a:xfrm>
            <a:off x="714348" y="127371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714348" y="1428736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714348" y="1643050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785786" y="191666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857224" y="227385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857224" y="270247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857224" y="305966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857224" y="334542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857224" y="413123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38" name="TextBox 37"/>
          <p:cNvSpPr txBox="1"/>
          <p:nvPr/>
        </p:nvSpPr>
        <p:spPr>
          <a:xfrm rot="-2700000">
            <a:off x="2107389" y="865311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39" name="TextBox 38"/>
          <p:cNvSpPr txBox="1"/>
          <p:nvPr/>
        </p:nvSpPr>
        <p:spPr>
          <a:xfrm rot="-2700000">
            <a:off x="2376435" y="73365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40" name="TextBox 39"/>
          <p:cNvSpPr txBox="1"/>
          <p:nvPr/>
        </p:nvSpPr>
        <p:spPr>
          <a:xfrm rot="-2700000">
            <a:off x="2811592" y="803799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41" name="TextBox 40"/>
          <p:cNvSpPr txBox="1"/>
          <p:nvPr/>
        </p:nvSpPr>
        <p:spPr>
          <a:xfrm rot="-2700000">
            <a:off x="3148996" y="583090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7379229" y="431472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7640706" y="4110840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7236736" y="5655720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7500958" y="54292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6" name="矩形 45"/>
          <p:cNvSpPr/>
          <p:nvPr/>
        </p:nvSpPr>
        <p:spPr>
          <a:xfrm>
            <a:off x="4143372" y="471488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47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4000496" y="3214686"/>
            <a:ext cx="142876" cy="221457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矩形 22"/>
          <p:cNvSpPr/>
          <p:nvPr/>
        </p:nvSpPr>
        <p:spPr>
          <a:xfrm>
            <a:off x="285720" y="357166"/>
            <a:ext cx="23446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6F LC3BII 2023.10.8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0" y="157161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0" y="172663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0" y="1857364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71438" y="2071678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42876" y="228599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142876" y="2559602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142876" y="284535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42876" y="305966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142876" y="3571876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33" name="TextBox 32"/>
          <p:cNvSpPr txBox="1"/>
          <p:nvPr/>
        </p:nvSpPr>
        <p:spPr>
          <a:xfrm rot="-2700000">
            <a:off x="1279065" y="120944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34" name="TextBox 33"/>
          <p:cNvSpPr txBox="1"/>
          <p:nvPr/>
        </p:nvSpPr>
        <p:spPr>
          <a:xfrm rot="-2700000">
            <a:off x="1529145" y="1057275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35" name="TextBox 34"/>
          <p:cNvSpPr txBox="1"/>
          <p:nvPr/>
        </p:nvSpPr>
        <p:spPr>
          <a:xfrm rot="-2700000">
            <a:off x="1874139" y="1162514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36" name="TextBox 35"/>
          <p:cNvSpPr txBox="1"/>
          <p:nvPr/>
        </p:nvSpPr>
        <p:spPr>
          <a:xfrm rot="-2700000">
            <a:off x="2111820" y="964389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16EA4B71-8A71-42CC-B812-7E1DBC9083DF}"/>
              </a:ext>
            </a:extLst>
          </p:cNvPr>
          <p:cNvCxnSpPr/>
          <p:nvPr/>
        </p:nvCxnSpPr>
        <p:spPr>
          <a:xfrm flipH="1">
            <a:off x="5739283" y="384719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23">
            <a:extLst>
              <a:ext uri="{FF2B5EF4-FFF2-40B4-BE49-F238E27FC236}">
                <a16:creationId xmlns:a16="http://schemas.microsoft.com/office/drawing/2014/main" id="{1D835D7B-45EC-43A4-BC90-86C838A60CC9}"/>
              </a:ext>
            </a:extLst>
          </p:cNvPr>
          <p:cNvSpPr txBox="1"/>
          <p:nvPr/>
        </p:nvSpPr>
        <p:spPr>
          <a:xfrm>
            <a:off x="6000760" y="3643314"/>
            <a:ext cx="7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C3BII</a:t>
            </a:r>
            <a:endParaRPr lang="zh-CN" altLang="en-US" dirty="0"/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FC81F3C7-61F5-4CD8-A7AD-983A72CCB88C}"/>
              </a:ext>
            </a:extLst>
          </p:cNvPr>
          <p:cNvCxnSpPr/>
          <p:nvPr/>
        </p:nvCxnSpPr>
        <p:spPr>
          <a:xfrm flipH="1">
            <a:off x="5715008" y="522709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28">
            <a:extLst>
              <a:ext uri="{FF2B5EF4-FFF2-40B4-BE49-F238E27FC236}">
                <a16:creationId xmlns:a16="http://schemas.microsoft.com/office/drawing/2014/main" id="{46627868-987A-47F2-A8BB-5E23E90144A5}"/>
              </a:ext>
            </a:extLst>
          </p:cNvPr>
          <p:cNvSpPr txBox="1"/>
          <p:nvPr/>
        </p:nvSpPr>
        <p:spPr>
          <a:xfrm>
            <a:off x="5979230" y="500063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41" name="矩形 40"/>
          <p:cNvSpPr/>
          <p:nvPr/>
        </p:nvSpPr>
        <p:spPr>
          <a:xfrm>
            <a:off x="3214678" y="4357694"/>
            <a:ext cx="2714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00100" y="1714488"/>
            <a:ext cx="4680000" cy="26792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00100" y="4786322"/>
            <a:ext cx="4680000" cy="8297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2" name="箭头: 下 24">
            <a:extLst>
              <a:ext uri="{FF2B5EF4-FFF2-40B4-BE49-F238E27FC236}">
                <a16:creationId xmlns:a16="http://schemas.microsoft.com/office/drawing/2014/main" id="{108B72B2-B426-465F-9295-953D746A62E7}"/>
              </a:ext>
            </a:extLst>
          </p:cNvPr>
          <p:cNvSpPr/>
          <p:nvPr/>
        </p:nvSpPr>
        <p:spPr>
          <a:xfrm>
            <a:off x="3000364" y="3143248"/>
            <a:ext cx="142876" cy="18573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14348" y="714356"/>
            <a:ext cx="18485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A  2023.9.29 </a:t>
            </a:r>
            <a:endParaRPr lang="zh-CN" alt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643050"/>
            <a:ext cx="4543425" cy="3533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4A2064F0-A43C-454D-B17D-67A0295F1A0E}"/>
              </a:ext>
            </a:extLst>
          </p:cNvPr>
          <p:cNvCxnSpPr/>
          <p:nvPr/>
        </p:nvCxnSpPr>
        <p:spPr>
          <a:xfrm flipH="1">
            <a:off x="6072198" y="2428868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30">
            <a:extLst>
              <a:ext uri="{FF2B5EF4-FFF2-40B4-BE49-F238E27FC236}">
                <a16:creationId xmlns:a16="http://schemas.microsoft.com/office/drawing/2014/main" id="{2EB1B906-2962-4059-9972-2515E3A9C2C9}"/>
              </a:ext>
            </a:extLst>
          </p:cNvPr>
          <p:cNvSpPr txBox="1"/>
          <p:nvPr/>
        </p:nvSpPr>
        <p:spPr>
          <a:xfrm>
            <a:off x="6286512" y="2214554"/>
            <a:ext cx="484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C95619F4-21CC-437A-89F8-909131154FB3}"/>
              </a:ext>
            </a:extLst>
          </p:cNvPr>
          <p:cNvCxnSpPr/>
          <p:nvPr/>
        </p:nvCxnSpPr>
        <p:spPr>
          <a:xfrm flipH="1">
            <a:off x="6072198" y="335756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32">
            <a:extLst>
              <a:ext uri="{FF2B5EF4-FFF2-40B4-BE49-F238E27FC236}">
                <a16:creationId xmlns:a16="http://schemas.microsoft.com/office/drawing/2014/main" id="{DFB827B7-A021-4488-B4E4-E7EFD5AA587E}"/>
              </a:ext>
            </a:extLst>
          </p:cNvPr>
          <p:cNvSpPr txBox="1"/>
          <p:nvPr/>
        </p:nvSpPr>
        <p:spPr>
          <a:xfrm>
            <a:off x="6286512" y="314324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71472" y="184522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71472" y="198809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71472" y="2143116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42910" y="241672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14348" y="270247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14348" y="3000372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14348" y="335756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714348" y="364331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714348" y="4214818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 rot="18900000">
            <a:off x="1801416" y="1192852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 rot="18900000">
            <a:off x="2113912" y="1032572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18900000">
            <a:off x="2543772" y="1079806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18900000">
            <a:off x="2905102" y="930202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0" y="928670"/>
            <a:ext cx="8806424" cy="4884205"/>
            <a:chOff x="0" y="928670"/>
            <a:chExt cx="8806424" cy="4884205"/>
          </a:xfrm>
        </p:grpSpPr>
        <p:grpSp>
          <p:nvGrpSpPr>
            <p:cNvPr id="3" name="组合 1"/>
            <p:cNvGrpSpPr/>
            <p:nvPr/>
          </p:nvGrpSpPr>
          <p:grpSpPr>
            <a:xfrm>
              <a:off x="0" y="2285992"/>
              <a:ext cx="8806424" cy="3526883"/>
              <a:chOff x="214282" y="3331117"/>
              <a:chExt cx="8806424" cy="3526883"/>
            </a:xfrm>
          </p:grpSpPr>
          <p:grpSp>
            <p:nvGrpSpPr>
              <p:cNvPr id="9" name="组合 43"/>
              <p:cNvGrpSpPr/>
              <p:nvPr/>
            </p:nvGrpSpPr>
            <p:grpSpPr>
              <a:xfrm>
                <a:off x="214282" y="3331117"/>
                <a:ext cx="5576894" cy="3526883"/>
                <a:chOff x="1214414" y="3273982"/>
                <a:chExt cx="5576894" cy="3526883"/>
              </a:xfrm>
            </p:grpSpPr>
            <p:pic>
              <p:nvPicPr>
                <p:cNvPr id="12" name="Picture 2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 bwMode="auto">
                <a:xfrm>
                  <a:off x="2143107" y="3286124"/>
                  <a:ext cx="4647600" cy="7474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3" name="Picture 3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2143108" y="4429132"/>
                  <a:ext cx="4647600" cy="51104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4" name="Picture 4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2143108" y="5572140"/>
                  <a:ext cx="4648200" cy="12287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5" name="Picture 5"/>
                <p:cNvPicPr>
                  <a:picLocks noChangeAspect="1" noChangeArrowheads="1"/>
                </p:cNvPicPr>
                <p:nvPr/>
              </p:nvPicPr>
              <p:blipFill>
                <a:blip r:embed="rId5"/>
                <a:srcRect/>
                <a:stretch>
                  <a:fillRect/>
                </a:stretch>
              </p:blipFill>
              <p:spPr bwMode="auto">
                <a:xfrm>
                  <a:off x="2138978" y="4929198"/>
                  <a:ext cx="4647600" cy="6328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6" name="Picture 6"/>
                <p:cNvPicPr>
                  <a:picLocks noChangeAspect="1" noChangeArrowheads="1"/>
                </p:cNvPicPr>
                <p:nvPr/>
              </p:nvPicPr>
              <p:blipFill>
                <a:blip r:embed="rId6"/>
                <a:srcRect/>
                <a:stretch>
                  <a:fillRect/>
                </a:stretch>
              </p:blipFill>
              <p:spPr bwMode="auto">
                <a:xfrm>
                  <a:off x="2143107" y="4014794"/>
                  <a:ext cx="4647600" cy="4867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7" name="TextBox 16"/>
                <p:cNvSpPr txBox="1"/>
                <p:nvPr/>
              </p:nvSpPr>
              <p:spPr>
                <a:xfrm>
                  <a:off x="1214414" y="3273982"/>
                  <a:ext cx="128588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70KDa-</a:t>
                  </a:r>
                  <a:endParaRPr lang="zh-CN" alt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1214414" y="3429000"/>
                  <a:ext cx="12144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30KDa-</a:t>
                  </a:r>
                  <a:endParaRPr lang="zh-CN" altLang="en-US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214414" y="392906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100KDa-</a:t>
                  </a:r>
                  <a:endParaRPr lang="zh-CN" alt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285852" y="4214818"/>
                  <a:ext cx="92869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70KDa-</a:t>
                  </a:r>
                  <a:endParaRPr lang="zh-CN" alt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357290" y="4786322"/>
                  <a:ext cx="11430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55KDa-</a:t>
                  </a:r>
                  <a:endParaRPr lang="zh-CN" alt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357290" y="535782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40KDa-</a:t>
                  </a:r>
                  <a:endParaRPr lang="zh-CN" altLang="en-US" dirty="0"/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357290" y="6000768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35KDa-</a:t>
                  </a:r>
                  <a:endParaRPr lang="zh-CN" altLang="en-US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1357290" y="6429396"/>
                  <a:ext cx="107157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/>
                    <a:t>25KDa-</a:t>
                  </a:r>
                  <a:endParaRPr lang="zh-CN" altLang="en-US" dirty="0"/>
                </a:p>
              </p:txBody>
            </p:sp>
          </p:grpSp>
          <p:pic>
            <p:nvPicPr>
              <p:cNvPr id="10" name="Picture 2"/>
              <p:cNvPicPr>
                <a:picLocks noChangeAspect="1"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6010418" y="5958176"/>
                <a:ext cx="3010288" cy="8976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6010418" y="5277328"/>
                <a:ext cx="26431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Stripping and Reprobing</a:t>
                </a:r>
                <a:endParaRPr lang="zh-CN" altLang="en-US" dirty="0"/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857224" y="928670"/>
              <a:ext cx="23574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Fig 3B 2020.6.23  </a:t>
              </a:r>
              <a:endParaRPr lang="zh-CN" alt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 rot="18900000">
              <a:off x="1484667" y="1764356"/>
              <a:ext cx="7858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.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 rot="18900000">
              <a:off x="1810639" y="1659803"/>
              <a:ext cx="12106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d20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2240499" y="1707037"/>
              <a:ext cx="9286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Azo</a:t>
              </a:r>
              <a:r>
                <a:rPr lang="en-US" altLang="zh-CN" dirty="0"/>
                <a:t> 20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 rot="18900000">
              <a:off x="2601829" y="1557433"/>
              <a:ext cx="1500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zo20+Cd20</a:t>
              </a:r>
              <a:endParaRPr lang="zh-CN" altLang="en-US" dirty="0"/>
            </a:p>
          </p:txBody>
        </p:sp>
      </p:grp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4A2064F0-A43C-454D-B17D-67A0295F1A0E}"/>
              </a:ext>
            </a:extLst>
          </p:cNvPr>
          <p:cNvCxnSpPr/>
          <p:nvPr/>
        </p:nvCxnSpPr>
        <p:spPr>
          <a:xfrm flipH="1">
            <a:off x="5648823" y="332143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30">
            <a:extLst>
              <a:ext uri="{FF2B5EF4-FFF2-40B4-BE49-F238E27FC236}">
                <a16:creationId xmlns:a16="http://schemas.microsoft.com/office/drawing/2014/main" id="{2EB1B906-2962-4059-9972-2515E3A9C2C9}"/>
              </a:ext>
            </a:extLst>
          </p:cNvPr>
          <p:cNvSpPr txBox="1"/>
          <p:nvPr/>
        </p:nvSpPr>
        <p:spPr>
          <a:xfrm>
            <a:off x="5910300" y="3143248"/>
            <a:ext cx="484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C95619F4-21CC-437A-89F8-909131154FB3}"/>
              </a:ext>
            </a:extLst>
          </p:cNvPr>
          <p:cNvCxnSpPr/>
          <p:nvPr/>
        </p:nvCxnSpPr>
        <p:spPr>
          <a:xfrm flipH="1">
            <a:off x="5648823" y="485042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32">
            <a:extLst>
              <a:ext uri="{FF2B5EF4-FFF2-40B4-BE49-F238E27FC236}">
                <a16:creationId xmlns:a16="http://schemas.microsoft.com/office/drawing/2014/main" id="{DFB827B7-A021-4488-B4E4-E7EFD5AA587E}"/>
              </a:ext>
            </a:extLst>
          </p:cNvPr>
          <p:cNvSpPr txBox="1"/>
          <p:nvPr/>
        </p:nvSpPr>
        <p:spPr>
          <a:xfrm>
            <a:off x="5910300" y="472132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9" name="箭头: 圆角右 24">
            <a:extLst>
              <a:ext uri="{FF2B5EF4-FFF2-40B4-BE49-F238E27FC236}">
                <a16:creationId xmlns:a16="http://schemas.microsoft.com/office/drawing/2014/main" id="{1D982F5B-6789-1D2C-786D-0591BE40AD6E}"/>
              </a:ext>
            </a:extLst>
          </p:cNvPr>
          <p:cNvSpPr/>
          <p:nvPr/>
        </p:nvSpPr>
        <p:spPr>
          <a:xfrm rot="5400000">
            <a:off x="6298675" y="4241495"/>
            <a:ext cx="360040" cy="1209203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49019" y="12693"/>
            <a:ext cx="19575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 3B 2023.9.29 1 </a:t>
            </a:r>
            <a:endParaRPr lang="zh-CN" altLang="en-US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8" y="1500174"/>
            <a:ext cx="4591050" cy="3600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286250" y="5214950"/>
            <a:ext cx="4857750" cy="1247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142844" y="157161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42844" y="1726630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2844" y="1928802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5720" y="2143116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85720" y="2428868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5720" y="2786058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85720" y="320254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85720" y="3500438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85720" y="414338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4A2064F0-A43C-454D-B17D-67A0295F1A0E}"/>
              </a:ext>
            </a:extLst>
          </p:cNvPr>
          <p:cNvCxnSpPr/>
          <p:nvPr/>
        </p:nvCxnSpPr>
        <p:spPr>
          <a:xfrm flipH="1">
            <a:off x="5739283" y="224986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30">
            <a:extLst>
              <a:ext uri="{FF2B5EF4-FFF2-40B4-BE49-F238E27FC236}">
                <a16:creationId xmlns:a16="http://schemas.microsoft.com/office/drawing/2014/main" id="{2EB1B906-2962-4059-9972-2515E3A9C2C9}"/>
              </a:ext>
            </a:extLst>
          </p:cNvPr>
          <p:cNvSpPr txBox="1"/>
          <p:nvPr/>
        </p:nvSpPr>
        <p:spPr>
          <a:xfrm>
            <a:off x="6000760" y="2071678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iP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C95619F4-21CC-437A-89F8-909131154FB3}"/>
              </a:ext>
            </a:extLst>
          </p:cNvPr>
          <p:cNvCxnSpPr/>
          <p:nvPr/>
        </p:nvCxnSpPr>
        <p:spPr>
          <a:xfrm>
            <a:off x="3929058" y="5986992"/>
            <a:ext cx="318588" cy="137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32">
            <a:extLst>
              <a:ext uri="{FF2B5EF4-FFF2-40B4-BE49-F238E27FC236}">
                <a16:creationId xmlns:a16="http://schemas.microsoft.com/office/drawing/2014/main" id="{DFB827B7-A021-4488-B4E4-E7EFD5AA587E}"/>
              </a:ext>
            </a:extLst>
          </p:cNvPr>
          <p:cNvSpPr txBox="1"/>
          <p:nvPr/>
        </p:nvSpPr>
        <p:spPr>
          <a:xfrm>
            <a:off x="3143240" y="578645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859550" y="2833212"/>
            <a:ext cx="2643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ripping and Reprobing</a:t>
            </a:r>
            <a:endParaRPr lang="zh-CN" altLang="en-US" dirty="0"/>
          </a:p>
        </p:txBody>
      </p:sp>
      <p:sp>
        <p:nvSpPr>
          <p:cNvPr id="21" name="箭头: 圆角右 24">
            <a:extLst>
              <a:ext uri="{FF2B5EF4-FFF2-40B4-BE49-F238E27FC236}">
                <a16:creationId xmlns:a16="http://schemas.microsoft.com/office/drawing/2014/main" id="{E6AA6798-24DA-4B58-9B30-CFED4C6E1951}"/>
              </a:ext>
            </a:extLst>
          </p:cNvPr>
          <p:cNvSpPr/>
          <p:nvPr/>
        </p:nvSpPr>
        <p:spPr>
          <a:xfrm rot="5400000">
            <a:off x="6215075" y="2714621"/>
            <a:ext cx="857253" cy="2000264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 rot="-2700000">
            <a:off x="2894516" y="1038085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23" name="TextBox 22"/>
          <p:cNvSpPr txBox="1"/>
          <p:nvPr/>
        </p:nvSpPr>
        <p:spPr>
          <a:xfrm rot="-2700000">
            <a:off x="3197018" y="884853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24" name="TextBox 23"/>
          <p:cNvSpPr txBox="1"/>
          <p:nvPr/>
        </p:nvSpPr>
        <p:spPr>
          <a:xfrm rot="-2700000">
            <a:off x="3638925" y="984540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25" name="TextBox 24"/>
          <p:cNvSpPr txBox="1"/>
          <p:nvPr/>
        </p:nvSpPr>
        <p:spPr>
          <a:xfrm rot="-2700000">
            <a:off x="3912397" y="750053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  <p:sp>
        <p:nvSpPr>
          <p:cNvPr id="3" name="TextBox 21">
            <a:extLst>
              <a:ext uri="{FF2B5EF4-FFF2-40B4-BE49-F238E27FC236}">
                <a16:creationId xmlns:a16="http://schemas.microsoft.com/office/drawing/2014/main" id="{370A8311-37E7-66F5-42DA-73E78EEB179A}"/>
              </a:ext>
            </a:extLst>
          </p:cNvPr>
          <p:cNvSpPr txBox="1"/>
          <p:nvPr/>
        </p:nvSpPr>
        <p:spPr>
          <a:xfrm rot="-2700000">
            <a:off x="1420498" y="987250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.</a:t>
            </a:r>
            <a:endParaRPr lang="zh-CN" altLang="en-US" dirty="0"/>
          </a:p>
        </p:txBody>
      </p:sp>
      <p:sp>
        <p:nvSpPr>
          <p:cNvPr id="4" name="TextBox 22">
            <a:extLst>
              <a:ext uri="{FF2B5EF4-FFF2-40B4-BE49-F238E27FC236}">
                <a16:creationId xmlns:a16="http://schemas.microsoft.com/office/drawing/2014/main" id="{679978F0-D0D5-D853-30C4-1936AFB3509A}"/>
              </a:ext>
            </a:extLst>
          </p:cNvPr>
          <p:cNvSpPr txBox="1"/>
          <p:nvPr/>
        </p:nvSpPr>
        <p:spPr>
          <a:xfrm rot="-2700000">
            <a:off x="1723000" y="834018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20</a:t>
            </a:r>
            <a:endParaRPr lang="zh-CN" altLang="en-US" dirty="0"/>
          </a:p>
        </p:txBody>
      </p:sp>
      <p:sp>
        <p:nvSpPr>
          <p:cNvPr id="18" name="TextBox 23">
            <a:extLst>
              <a:ext uri="{FF2B5EF4-FFF2-40B4-BE49-F238E27FC236}">
                <a16:creationId xmlns:a16="http://schemas.microsoft.com/office/drawing/2014/main" id="{31823FF6-046C-8759-B934-308E10ABF4DA}"/>
              </a:ext>
            </a:extLst>
          </p:cNvPr>
          <p:cNvSpPr txBox="1"/>
          <p:nvPr/>
        </p:nvSpPr>
        <p:spPr>
          <a:xfrm rot="-2700000">
            <a:off x="2164907" y="933705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Azo</a:t>
            </a:r>
            <a:r>
              <a:rPr lang="en-US" altLang="zh-CN" dirty="0"/>
              <a:t> 20</a:t>
            </a:r>
            <a:endParaRPr lang="zh-CN" altLang="en-US" dirty="0"/>
          </a:p>
        </p:txBody>
      </p:sp>
      <p:sp>
        <p:nvSpPr>
          <p:cNvPr id="19" name="TextBox 24">
            <a:extLst>
              <a:ext uri="{FF2B5EF4-FFF2-40B4-BE49-F238E27FC236}">
                <a16:creationId xmlns:a16="http://schemas.microsoft.com/office/drawing/2014/main" id="{0C237579-ACFD-BD3B-BE2F-77B3AB9B5D99}"/>
              </a:ext>
            </a:extLst>
          </p:cNvPr>
          <p:cNvSpPr txBox="1"/>
          <p:nvPr/>
        </p:nvSpPr>
        <p:spPr>
          <a:xfrm rot="-2700000">
            <a:off x="2438379" y="699218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zo20+Cd20</a:t>
            </a:r>
            <a:endParaRPr lang="zh-CN" alt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42910" y="500042"/>
            <a:ext cx="3357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3C  2023.9.29 1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 rot="-2700000">
            <a:off x="3000250" y="1755914"/>
            <a:ext cx="785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-2700000">
            <a:off x="3346443" y="1605710"/>
            <a:ext cx="1210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-2700000">
            <a:off x="3788247" y="1680713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Az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-2700000">
            <a:off x="4081641" y="1397734"/>
            <a:ext cx="1675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zo20+Cd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4C538B2D-56C1-40F5-B3C5-4E25A09DEFD3}"/>
              </a:ext>
            </a:extLst>
          </p:cNvPr>
          <p:cNvCxnSpPr/>
          <p:nvPr/>
        </p:nvCxnSpPr>
        <p:spPr>
          <a:xfrm flipH="1">
            <a:off x="5643570" y="2643182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5">
            <a:extLst>
              <a:ext uri="{FF2B5EF4-FFF2-40B4-BE49-F238E27FC236}">
                <a16:creationId xmlns:a16="http://schemas.microsoft.com/office/drawing/2014/main" id="{779D64C5-6677-410E-B5BA-816CC6EFCFF6}"/>
              </a:ext>
            </a:extLst>
          </p:cNvPr>
          <p:cNvSpPr txBox="1"/>
          <p:nvPr/>
        </p:nvSpPr>
        <p:spPr>
          <a:xfrm>
            <a:off x="5812666" y="2428868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ERK</a:t>
            </a:r>
            <a:endParaRPr lang="zh-CN" altLang="en-US" dirty="0"/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9B0BF4A5-F613-4319-A74A-A145EC251EC9}"/>
              </a:ext>
            </a:extLst>
          </p:cNvPr>
          <p:cNvCxnSpPr/>
          <p:nvPr/>
        </p:nvCxnSpPr>
        <p:spPr>
          <a:xfrm flipH="1">
            <a:off x="5643570" y="3845486"/>
            <a:ext cx="240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29">
            <a:extLst>
              <a:ext uri="{FF2B5EF4-FFF2-40B4-BE49-F238E27FC236}">
                <a16:creationId xmlns:a16="http://schemas.microsoft.com/office/drawing/2014/main" id="{0CFFCED0-ACE4-4464-BCC4-26DC2640BA57}"/>
              </a:ext>
            </a:extLst>
          </p:cNvPr>
          <p:cNvSpPr txBox="1"/>
          <p:nvPr/>
        </p:nvSpPr>
        <p:spPr>
          <a:xfrm>
            <a:off x="5857884" y="363117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28596" y="2488164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0KDa-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28596" y="255960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30KDa-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57158" y="2786058"/>
            <a:ext cx="142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KDa-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28596" y="2988230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KDa-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28596" y="3273982"/>
            <a:ext cx="92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KDa-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28596" y="3559734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0KDa-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28596" y="3916924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5KDa-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28596" y="4702742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KDa-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428596" y="4131238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5KDa-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85852" y="2285992"/>
            <a:ext cx="4320000" cy="3405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wrap="none">
        <a:spAutoFit/>
      </a:bodyPr>
      <a:lstStyle>
        <a:defPPr algn="l">
          <a:defRPr dirty="0"/>
        </a:defPPr>
      </a:lstStyle>
    </a:spDef>
    <a:txDef>
      <a:spPr>
        <a:noFill/>
      </a:spPr>
      <a:bodyPr wrap="square" rtlCol="0">
        <a:spAutoFit/>
      </a:bodyPr>
      <a:lstStyle>
        <a:defPPr algn="l">
          <a:defRPr dirty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8</TotalTime>
  <Words>1377</Words>
  <Application>Microsoft Office PowerPoint</Application>
  <PresentationFormat>全屏显示(4:3)</PresentationFormat>
  <Paragraphs>911</Paragraphs>
  <Slides>5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4</vt:i4>
      </vt:variant>
    </vt:vector>
  </HeadingPairs>
  <TitlesOfParts>
    <vt:vector size="57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李 杰</cp:lastModifiedBy>
  <cp:revision>444</cp:revision>
  <dcterms:created xsi:type="dcterms:W3CDTF">2023-07-11T02:02:42Z</dcterms:created>
  <dcterms:modified xsi:type="dcterms:W3CDTF">2023-11-05T09:59:59Z</dcterms:modified>
</cp:coreProperties>
</file>